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11555413" cy="70199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11" userDrawn="1">
          <p15:clr>
            <a:srgbClr val="A4A3A4"/>
          </p15:clr>
        </p15:guide>
        <p15:guide id="2" pos="36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07E3"/>
    <a:srgbClr val="008000"/>
    <a:srgbClr val="FF8000"/>
    <a:srgbClr val="0000FF"/>
    <a:srgbClr val="FC4E07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810" y="114"/>
      </p:cViewPr>
      <p:guideLst>
        <p:guide orient="horz" pos="2211"/>
        <p:guide pos="36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MMERT-TRIPON Marine" userId="957e260d-45d9-4bce-a44b-dc5e8c7cd978" providerId="ADAL" clId="{08E46F95-2A52-44E2-AB55-5FAEC58055D2}"/>
    <pc:docChg chg="modSld">
      <pc:chgData name="MOMMERT-TRIPON Marine" userId="957e260d-45d9-4bce-a44b-dc5e8c7cd978" providerId="ADAL" clId="{08E46F95-2A52-44E2-AB55-5FAEC58055D2}" dt="2024-10-24T14:42:15.459" v="6" actId="13926"/>
      <pc:docMkLst>
        <pc:docMk/>
      </pc:docMkLst>
      <pc:sldChg chg="modSp mod">
        <pc:chgData name="MOMMERT-TRIPON Marine" userId="957e260d-45d9-4bce-a44b-dc5e8c7cd978" providerId="ADAL" clId="{08E46F95-2A52-44E2-AB55-5FAEC58055D2}" dt="2024-10-24T14:42:15.459" v="6" actId="13926"/>
        <pc:sldMkLst>
          <pc:docMk/>
          <pc:sldMk cId="4051420417" sldId="258"/>
        </pc:sldMkLst>
        <pc:spChg chg="mod">
          <ac:chgData name="MOMMERT-TRIPON Marine" userId="957e260d-45d9-4bce-a44b-dc5e8c7cd978" providerId="ADAL" clId="{08E46F95-2A52-44E2-AB55-5FAEC58055D2}" dt="2024-10-24T14:42:15.459" v="6" actId="13926"/>
          <ac:spMkLst>
            <pc:docMk/>
            <pc:sldMk cId="4051420417" sldId="258"/>
            <ac:spMk id="127" creationId="{22B7E908-6033-48B3-845D-ADA3D810E571}"/>
          </ac:spMkLst>
        </pc:spChg>
        <pc:spChg chg="mod">
          <ac:chgData name="MOMMERT-TRIPON Marine" userId="957e260d-45d9-4bce-a44b-dc5e8c7cd978" providerId="ADAL" clId="{08E46F95-2A52-44E2-AB55-5FAEC58055D2}" dt="2024-10-24T14:42:10.687" v="5" actId="13926"/>
          <ac:spMkLst>
            <pc:docMk/>
            <pc:sldMk cId="4051420417" sldId="258"/>
            <ac:spMk id="154" creationId="{C09F2A34-F177-4B6D-B2C8-B0CF8C1AA163}"/>
          </ac:spMkLst>
        </pc:spChg>
        <pc:spChg chg="mod">
          <ac:chgData name="MOMMERT-TRIPON Marine" userId="957e260d-45d9-4bce-a44b-dc5e8c7cd978" providerId="ADAL" clId="{08E46F95-2A52-44E2-AB55-5FAEC58055D2}" dt="2024-10-24T14:42:03.312" v="3" actId="13926"/>
          <ac:spMkLst>
            <pc:docMk/>
            <pc:sldMk cId="4051420417" sldId="258"/>
            <ac:spMk id="159" creationId="{62C15DA9-C596-4D42-B56B-2F730FBB91B5}"/>
          </ac:spMkLst>
        </pc:spChg>
        <pc:spChg chg="mod">
          <ac:chgData name="MOMMERT-TRIPON Marine" userId="957e260d-45d9-4bce-a44b-dc5e8c7cd978" providerId="ADAL" clId="{08E46F95-2A52-44E2-AB55-5FAEC58055D2}" dt="2024-10-24T14:41:59.107" v="2" actId="13926"/>
          <ac:spMkLst>
            <pc:docMk/>
            <pc:sldMk cId="4051420417" sldId="258"/>
            <ac:spMk id="164" creationId="{68AA0751-2F7F-4C7A-A3A2-2048AAE34227}"/>
          </ac:spMkLst>
        </pc:spChg>
        <pc:spChg chg="mod">
          <ac:chgData name="MOMMERT-TRIPON Marine" userId="957e260d-45d9-4bce-a44b-dc5e8c7cd978" providerId="ADAL" clId="{08E46F95-2A52-44E2-AB55-5FAEC58055D2}" dt="2024-10-24T14:41:52.164" v="0" actId="13926"/>
          <ac:spMkLst>
            <pc:docMk/>
            <pc:sldMk cId="4051420417" sldId="258"/>
            <ac:spMk id="168" creationId="{85FE9545-32CC-4E21-AE0F-6BA1118F2006}"/>
          </ac:spMkLst>
        </pc:spChg>
        <pc:spChg chg="mod">
          <ac:chgData name="MOMMERT-TRIPON Marine" userId="957e260d-45d9-4bce-a44b-dc5e8c7cd978" providerId="ADAL" clId="{08E46F95-2A52-44E2-AB55-5FAEC58055D2}" dt="2024-10-24T14:41:56.508" v="1" actId="13926"/>
          <ac:spMkLst>
            <pc:docMk/>
            <pc:sldMk cId="4051420417" sldId="258"/>
            <ac:spMk id="169" creationId="{3C8FED33-5EC3-457C-84E4-D6BA9B32CCC9}"/>
          </ac:spMkLst>
        </pc:spChg>
      </pc:sldChg>
    </pc:docChg>
  </pc:docChgLst>
  <pc:docChgLst>
    <pc:chgData name="GROSBOIS Cloé" userId="5f57a020-64f6-4ab3-8391-eb78b3388ff7" providerId="ADAL" clId="{78081A45-0C38-4205-B1A2-832DF94CA3DB}"/>
    <pc:docChg chg="modSld">
      <pc:chgData name="GROSBOIS Cloé" userId="5f57a020-64f6-4ab3-8391-eb78b3388ff7" providerId="ADAL" clId="{78081A45-0C38-4205-B1A2-832DF94CA3DB}" dt="2024-11-13T15:19:57.877" v="51" actId="20577"/>
      <pc:docMkLst>
        <pc:docMk/>
      </pc:docMkLst>
      <pc:sldChg chg="modSp mod">
        <pc:chgData name="GROSBOIS Cloé" userId="5f57a020-64f6-4ab3-8391-eb78b3388ff7" providerId="ADAL" clId="{78081A45-0C38-4205-B1A2-832DF94CA3DB}" dt="2024-11-13T15:19:57.877" v="51" actId="20577"/>
        <pc:sldMkLst>
          <pc:docMk/>
          <pc:sldMk cId="4051420417" sldId="258"/>
        </pc:sldMkLst>
        <pc:spChg chg="mod">
          <ac:chgData name="GROSBOIS Cloé" userId="5f57a020-64f6-4ab3-8391-eb78b3388ff7" providerId="ADAL" clId="{78081A45-0C38-4205-B1A2-832DF94CA3DB}" dt="2024-11-13T15:19:48.684" v="45" actId="20577"/>
          <ac:spMkLst>
            <pc:docMk/>
            <pc:sldMk cId="4051420417" sldId="258"/>
            <ac:spMk id="126" creationId="{9310E8FB-89C8-4A26-BD17-2279118138A3}"/>
          </ac:spMkLst>
        </pc:spChg>
        <pc:spChg chg="mod">
          <ac:chgData name="GROSBOIS Cloé" userId="5f57a020-64f6-4ab3-8391-eb78b3388ff7" providerId="ADAL" clId="{78081A45-0C38-4205-B1A2-832DF94CA3DB}" dt="2024-11-13T15:19:57.877" v="51" actId="20577"/>
          <ac:spMkLst>
            <pc:docMk/>
            <pc:sldMk cId="4051420417" sldId="258"/>
            <ac:spMk id="127" creationId="{22B7E908-6033-48B3-845D-ADA3D810E571}"/>
          </ac:spMkLst>
        </pc:spChg>
        <pc:spChg chg="mod">
          <ac:chgData name="GROSBOIS Cloé" userId="5f57a020-64f6-4ab3-8391-eb78b3388ff7" providerId="ADAL" clId="{78081A45-0C38-4205-B1A2-832DF94CA3DB}" dt="2024-11-13T15:19:37.893" v="37" actId="20577"/>
          <ac:spMkLst>
            <pc:docMk/>
            <pc:sldMk cId="4051420417" sldId="258"/>
            <ac:spMk id="137" creationId="{BCE5E8C3-484E-461E-8877-4126101935A0}"/>
          </ac:spMkLst>
        </pc:spChg>
        <pc:spChg chg="mod">
          <ac:chgData name="GROSBOIS Cloé" userId="5f57a020-64f6-4ab3-8391-eb78b3388ff7" providerId="ADAL" clId="{78081A45-0C38-4205-B1A2-832DF94CA3DB}" dt="2024-11-13T15:18:47.709" v="1" actId="20577"/>
          <ac:spMkLst>
            <pc:docMk/>
            <pc:sldMk cId="4051420417" sldId="258"/>
            <ac:spMk id="142" creationId="{8CE2A9FE-AEBA-DF9F-FCDA-59B04C7FEF60}"/>
          </ac:spMkLst>
        </pc:spChg>
        <pc:spChg chg="mod">
          <ac:chgData name="GROSBOIS Cloé" userId="5f57a020-64f6-4ab3-8391-eb78b3388ff7" providerId="ADAL" clId="{78081A45-0C38-4205-B1A2-832DF94CA3DB}" dt="2024-11-13T15:18:50.426" v="3" actId="20577"/>
          <ac:spMkLst>
            <pc:docMk/>
            <pc:sldMk cId="4051420417" sldId="258"/>
            <ac:spMk id="143" creationId="{C9C74C70-2B9D-89B0-BDAD-50FCD567F3A1}"/>
          </ac:spMkLst>
        </pc:spChg>
        <pc:spChg chg="mod">
          <ac:chgData name="GROSBOIS Cloé" userId="5f57a020-64f6-4ab3-8391-eb78b3388ff7" providerId="ADAL" clId="{78081A45-0C38-4205-B1A2-832DF94CA3DB}" dt="2024-11-13T15:18:52.899" v="5" actId="20577"/>
          <ac:spMkLst>
            <pc:docMk/>
            <pc:sldMk cId="4051420417" sldId="258"/>
            <ac:spMk id="144" creationId="{6372D1A8-6B5A-9138-1141-F67FDCC1652F}"/>
          </ac:spMkLst>
        </pc:spChg>
        <pc:spChg chg="mod">
          <ac:chgData name="GROSBOIS Cloé" userId="5f57a020-64f6-4ab3-8391-eb78b3388ff7" providerId="ADAL" clId="{78081A45-0C38-4205-B1A2-832DF94CA3DB}" dt="2024-11-13T15:18:55.324" v="7" actId="20577"/>
          <ac:spMkLst>
            <pc:docMk/>
            <pc:sldMk cId="4051420417" sldId="258"/>
            <ac:spMk id="145" creationId="{3E28E9C1-C9F6-A3B9-22A1-F1EC09C5AB63}"/>
          </ac:spMkLst>
        </pc:spChg>
        <pc:spChg chg="mod">
          <ac:chgData name="GROSBOIS Cloé" userId="5f57a020-64f6-4ab3-8391-eb78b3388ff7" providerId="ADAL" clId="{78081A45-0C38-4205-B1A2-832DF94CA3DB}" dt="2024-11-13T15:18:57.763" v="9" actId="20577"/>
          <ac:spMkLst>
            <pc:docMk/>
            <pc:sldMk cId="4051420417" sldId="258"/>
            <ac:spMk id="146" creationId="{8D2EC4CE-E516-97D0-23D3-4A5A69909006}"/>
          </ac:spMkLst>
        </pc:spChg>
        <pc:spChg chg="mod">
          <ac:chgData name="GROSBOIS Cloé" userId="5f57a020-64f6-4ab3-8391-eb78b3388ff7" providerId="ADAL" clId="{78081A45-0C38-4205-B1A2-832DF94CA3DB}" dt="2024-11-13T15:19:45.886" v="43" actId="20577"/>
          <ac:spMkLst>
            <pc:docMk/>
            <pc:sldMk cId="4051420417" sldId="258"/>
            <ac:spMk id="154" creationId="{C09F2A34-F177-4B6D-B2C8-B0CF8C1AA163}"/>
          </ac:spMkLst>
        </pc:spChg>
        <pc:spChg chg="mod">
          <ac:chgData name="GROSBOIS Cloé" userId="5f57a020-64f6-4ab3-8391-eb78b3388ff7" providerId="ADAL" clId="{78081A45-0C38-4205-B1A2-832DF94CA3DB}" dt="2024-11-13T15:19:27.565" v="29" actId="20577"/>
          <ac:spMkLst>
            <pc:docMk/>
            <pc:sldMk cId="4051420417" sldId="258"/>
            <ac:spMk id="158" creationId="{1EF15A67-FD82-40DD-A4DC-A9B766B4AF1F}"/>
          </ac:spMkLst>
        </pc:spChg>
        <pc:spChg chg="mod">
          <ac:chgData name="GROSBOIS Cloé" userId="5f57a020-64f6-4ab3-8391-eb78b3388ff7" providerId="ADAL" clId="{78081A45-0C38-4205-B1A2-832DF94CA3DB}" dt="2024-11-13T15:19:35.225" v="35" actId="20577"/>
          <ac:spMkLst>
            <pc:docMk/>
            <pc:sldMk cId="4051420417" sldId="258"/>
            <ac:spMk id="159" creationId="{62C15DA9-C596-4D42-B56B-2F730FBB91B5}"/>
          </ac:spMkLst>
        </pc:spChg>
        <pc:spChg chg="mod">
          <ac:chgData name="GROSBOIS Cloé" userId="5f57a020-64f6-4ab3-8391-eb78b3388ff7" providerId="ADAL" clId="{78081A45-0C38-4205-B1A2-832DF94CA3DB}" dt="2024-11-13T15:19:10.612" v="19" actId="20577"/>
          <ac:spMkLst>
            <pc:docMk/>
            <pc:sldMk cId="4051420417" sldId="258"/>
            <ac:spMk id="163" creationId="{FDC586B1-15AA-45E2-B158-DE001EC17821}"/>
          </ac:spMkLst>
        </pc:spChg>
        <pc:spChg chg="mod">
          <ac:chgData name="GROSBOIS Cloé" userId="5f57a020-64f6-4ab3-8391-eb78b3388ff7" providerId="ADAL" clId="{78081A45-0C38-4205-B1A2-832DF94CA3DB}" dt="2024-11-13T15:19:19.532" v="27" actId="20577"/>
          <ac:spMkLst>
            <pc:docMk/>
            <pc:sldMk cId="4051420417" sldId="258"/>
            <ac:spMk id="164" creationId="{68AA0751-2F7F-4C7A-A3A2-2048AAE34227}"/>
          </ac:spMkLst>
        </pc:spChg>
        <pc:spChg chg="mod">
          <ac:chgData name="GROSBOIS Cloé" userId="5f57a020-64f6-4ab3-8391-eb78b3388ff7" providerId="ADAL" clId="{78081A45-0C38-4205-B1A2-832DF94CA3DB}" dt="2024-11-13T15:19:00.988" v="11" actId="20577"/>
          <ac:spMkLst>
            <pc:docMk/>
            <pc:sldMk cId="4051420417" sldId="258"/>
            <ac:spMk id="168" creationId="{85FE9545-32CC-4E21-AE0F-6BA1118F2006}"/>
          </ac:spMkLst>
        </pc:spChg>
        <pc:spChg chg="mod">
          <ac:chgData name="GROSBOIS Cloé" userId="5f57a020-64f6-4ab3-8391-eb78b3388ff7" providerId="ADAL" clId="{78081A45-0C38-4205-B1A2-832DF94CA3DB}" dt="2024-11-13T15:19:08.028" v="17" actId="20577"/>
          <ac:spMkLst>
            <pc:docMk/>
            <pc:sldMk cId="4051420417" sldId="258"/>
            <ac:spMk id="169" creationId="{3C8FED33-5EC3-457C-84E4-D6BA9B32CCC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44427" y="1148863"/>
            <a:ext cx="8666560" cy="2443974"/>
          </a:xfrm>
        </p:spPr>
        <p:txBody>
          <a:bodyPr anchor="b"/>
          <a:lstStyle>
            <a:lvl1pPr algn="ctr">
              <a:defRPr sz="568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4427" y="3687086"/>
            <a:ext cx="8666560" cy="1694856"/>
          </a:xfrm>
        </p:spPr>
        <p:txBody>
          <a:bodyPr/>
          <a:lstStyle>
            <a:lvl1pPr marL="0" indent="0" algn="ctr">
              <a:buNone/>
              <a:defRPr sz="2275"/>
            </a:lvl1pPr>
            <a:lvl2pPr marL="433334" indent="0" algn="ctr">
              <a:buNone/>
              <a:defRPr sz="1896"/>
            </a:lvl2pPr>
            <a:lvl3pPr marL="866668" indent="0" algn="ctr">
              <a:buNone/>
              <a:defRPr sz="1706"/>
            </a:lvl3pPr>
            <a:lvl4pPr marL="1300002" indent="0" algn="ctr">
              <a:buNone/>
              <a:defRPr sz="1516"/>
            </a:lvl4pPr>
            <a:lvl5pPr marL="1733337" indent="0" algn="ctr">
              <a:buNone/>
              <a:defRPr sz="1516"/>
            </a:lvl5pPr>
            <a:lvl6pPr marL="2166671" indent="0" algn="ctr">
              <a:buNone/>
              <a:defRPr sz="1516"/>
            </a:lvl6pPr>
            <a:lvl7pPr marL="2600005" indent="0" algn="ctr">
              <a:buNone/>
              <a:defRPr sz="1516"/>
            </a:lvl7pPr>
            <a:lvl8pPr marL="3033339" indent="0" algn="ctr">
              <a:buNone/>
              <a:defRPr sz="1516"/>
            </a:lvl8pPr>
            <a:lvl9pPr marL="3466673" indent="0" algn="ctr">
              <a:buNone/>
              <a:defRPr sz="1516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2033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67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269342" y="373746"/>
            <a:ext cx="2491636" cy="5949062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94435" y="373746"/>
            <a:ext cx="7330465" cy="5949062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8570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67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8416" y="1750107"/>
            <a:ext cx="9966544" cy="2920093"/>
          </a:xfrm>
        </p:spPr>
        <p:txBody>
          <a:bodyPr anchor="b"/>
          <a:lstStyle>
            <a:lvl1pPr>
              <a:defRPr sz="568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8416" y="4697826"/>
            <a:ext cx="9966544" cy="1535608"/>
          </a:xfrm>
        </p:spPr>
        <p:txBody>
          <a:bodyPr/>
          <a:lstStyle>
            <a:lvl1pPr marL="0" indent="0">
              <a:buNone/>
              <a:defRPr sz="2275">
                <a:solidFill>
                  <a:schemeClr val="tx1">
                    <a:tint val="75000"/>
                  </a:schemeClr>
                </a:solidFill>
              </a:defRPr>
            </a:lvl1pPr>
            <a:lvl2pPr marL="433334" indent="0">
              <a:buNone/>
              <a:defRPr sz="1896">
                <a:solidFill>
                  <a:schemeClr val="tx1">
                    <a:tint val="75000"/>
                  </a:schemeClr>
                </a:solidFill>
              </a:defRPr>
            </a:lvl2pPr>
            <a:lvl3pPr marL="866668" indent="0">
              <a:buNone/>
              <a:defRPr sz="1706">
                <a:solidFill>
                  <a:schemeClr val="tx1">
                    <a:tint val="75000"/>
                  </a:schemeClr>
                </a:solidFill>
              </a:defRPr>
            </a:lvl3pPr>
            <a:lvl4pPr marL="1300002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4pPr>
            <a:lvl5pPr marL="1733337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5pPr>
            <a:lvl6pPr marL="2166671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6pPr>
            <a:lvl7pPr marL="2600005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7pPr>
            <a:lvl8pPr marL="3033339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8pPr>
            <a:lvl9pPr marL="3466673" indent="0">
              <a:buNone/>
              <a:defRPr sz="151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5314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94434" y="1868730"/>
            <a:ext cx="4911051" cy="445407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49928" y="1868730"/>
            <a:ext cx="4911051" cy="445407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2843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5940" y="373747"/>
            <a:ext cx="9966544" cy="1356861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5940" y="1720857"/>
            <a:ext cx="4888481" cy="843365"/>
          </a:xfrm>
        </p:spPr>
        <p:txBody>
          <a:bodyPr anchor="b"/>
          <a:lstStyle>
            <a:lvl1pPr marL="0" indent="0">
              <a:buNone/>
              <a:defRPr sz="2275" b="1"/>
            </a:lvl1pPr>
            <a:lvl2pPr marL="433334" indent="0">
              <a:buNone/>
              <a:defRPr sz="1896" b="1"/>
            </a:lvl2pPr>
            <a:lvl3pPr marL="866668" indent="0">
              <a:buNone/>
              <a:defRPr sz="1706" b="1"/>
            </a:lvl3pPr>
            <a:lvl4pPr marL="1300002" indent="0">
              <a:buNone/>
              <a:defRPr sz="1516" b="1"/>
            </a:lvl4pPr>
            <a:lvl5pPr marL="1733337" indent="0">
              <a:buNone/>
              <a:defRPr sz="1516" b="1"/>
            </a:lvl5pPr>
            <a:lvl6pPr marL="2166671" indent="0">
              <a:buNone/>
              <a:defRPr sz="1516" b="1"/>
            </a:lvl6pPr>
            <a:lvl7pPr marL="2600005" indent="0">
              <a:buNone/>
              <a:defRPr sz="1516" b="1"/>
            </a:lvl7pPr>
            <a:lvl8pPr marL="3033339" indent="0">
              <a:buNone/>
              <a:defRPr sz="1516" b="1"/>
            </a:lvl8pPr>
            <a:lvl9pPr marL="3466673" indent="0">
              <a:buNone/>
              <a:defRPr sz="1516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5940" y="2564223"/>
            <a:ext cx="4888481" cy="377158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49928" y="1720857"/>
            <a:ext cx="4912556" cy="843365"/>
          </a:xfrm>
        </p:spPr>
        <p:txBody>
          <a:bodyPr anchor="b"/>
          <a:lstStyle>
            <a:lvl1pPr marL="0" indent="0">
              <a:buNone/>
              <a:defRPr sz="2275" b="1"/>
            </a:lvl1pPr>
            <a:lvl2pPr marL="433334" indent="0">
              <a:buNone/>
              <a:defRPr sz="1896" b="1"/>
            </a:lvl2pPr>
            <a:lvl3pPr marL="866668" indent="0">
              <a:buNone/>
              <a:defRPr sz="1706" b="1"/>
            </a:lvl3pPr>
            <a:lvl4pPr marL="1300002" indent="0">
              <a:buNone/>
              <a:defRPr sz="1516" b="1"/>
            </a:lvl4pPr>
            <a:lvl5pPr marL="1733337" indent="0">
              <a:buNone/>
              <a:defRPr sz="1516" b="1"/>
            </a:lvl5pPr>
            <a:lvl6pPr marL="2166671" indent="0">
              <a:buNone/>
              <a:defRPr sz="1516" b="1"/>
            </a:lvl6pPr>
            <a:lvl7pPr marL="2600005" indent="0">
              <a:buNone/>
              <a:defRPr sz="1516" b="1"/>
            </a:lvl7pPr>
            <a:lvl8pPr marL="3033339" indent="0">
              <a:buNone/>
              <a:defRPr sz="1516" b="1"/>
            </a:lvl8pPr>
            <a:lvl9pPr marL="3466673" indent="0">
              <a:buNone/>
              <a:defRPr sz="1516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49928" y="2564223"/>
            <a:ext cx="4912556" cy="3771585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578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5255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0554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5940" y="467995"/>
            <a:ext cx="3726921" cy="1637983"/>
          </a:xfrm>
        </p:spPr>
        <p:txBody>
          <a:bodyPr anchor="b"/>
          <a:lstStyle>
            <a:lvl1pPr>
              <a:defRPr sz="303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12556" y="1010740"/>
            <a:ext cx="5849928" cy="4988697"/>
          </a:xfrm>
        </p:spPr>
        <p:txBody>
          <a:bodyPr/>
          <a:lstStyle>
            <a:lvl1pPr>
              <a:defRPr sz="3033"/>
            </a:lvl1pPr>
            <a:lvl2pPr>
              <a:defRPr sz="2654"/>
            </a:lvl2pPr>
            <a:lvl3pPr>
              <a:defRPr sz="2275"/>
            </a:lvl3pPr>
            <a:lvl4pPr>
              <a:defRPr sz="1896"/>
            </a:lvl4pPr>
            <a:lvl5pPr>
              <a:defRPr sz="1896"/>
            </a:lvl5pPr>
            <a:lvl6pPr>
              <a:defRPr sz="1896"/>
            </a:lvl6pPr>
            <a:lvl7pPr>
              <a:defRPr sz="1896"/>
            </a:lvl7pPr>
            <a:lvl8pPr>
              <a:defRPr sz="1896"/>
            </a:lvl8pPr>
            <a:lvl9pPr>
              <a:defRPr sz="1896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5940" y="2105977"/>
            <a:ext cx="3726921" cy="3901584"/>
          </a:xfrm>
        </p:spPr>
        <p:txBody>
          <a:bodyPr/>
          <a:lstStyle>
            <a:lvl1pPr marL="0" indent="0">
              <a:buNone/>
              <a:defRPr sz="1516"/>
            </a:lvl1pPr>
            <a:lvl2pPr marL="433334" indent="0">
              <a:buNone/>
              <a:defRPr sz="1327"/>
            </a:lvl2pPr>
            <a:lvl3pPr marL="866668" indent="0">
              <a:buNone/>
              <a:defRPr sz="1137"/>
            </a:lvl3pPr>
            <a:lvl4pPr marL="1300002" indent="0">
              <a:buNone/>
              <a:defRPr sz="948"/>
            </a:lvl4pPr>
            <a:lvl5pPr marL="1733337" indent="0">
              <a:buNone/>
              <a:defRPr sz="948"/>
            </a:lvl5pPr>
            <a:lvl6pPr marL="2166671" indent="0">
              <a:buNone/>
              <a:defRPr sz="948"/>
            </a:lvl6pPr>
            <a:lvl7pPr marL="2600005" indent="0">
              <a:buNone/>
              <a:defRPr sz="948"/>
            </a:lvl7pPr>
            <a:lvl8pPr marL="3033339" indent="0">
              <a:buNone/>
              <a:defRPr sz="948"/>
            </a:lvl8pPr>
            <a:lvl9pPr marL="3466673" indent="0">
              <a:buNone/>
              <a:defRPr sz="948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0323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5940" y="467995"/>
            <a:ext cx="3726921" cy="1637983"/>
          </a:xfrm>
        </p:spPr>
        <p:txBody>
          <a:bodyPr anchor="b"/>
          <a:lstStyle>
            <a:lvl1pPr>
              <a:defRPr sz="303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912556" y="1010740"/>
            <a:ext cx="5849928" cy="4988697"/>
          </a:xfrm>
        </p:spPr>
        <p:txBody>
          <a:bodyPr anchor="t"/>
          <a:lstStyle>
            <a:lvl1pPr marL="0" indent="0">
              <a:buNone/>
              <a:defRPr sz="3033"/>
            </a:lvl1pPr>
            <a:lvl2pPr marL="433334" indent="0">
              <a:buNone/>
              <a:defRPr sz="2654"/>
            </a:lvl2pPr>
            <a:lvl3pPr marL="866668" indent="0">
              <a:buNone/>
              <a:defRPr sz="2275"/>
            </a:lvl3pPr>
            <a:lvl4pPr marL="1300002" indent="0">
              <a:buNone/>
              <a:defRPr sz="1896"/>
            </a:lvl4pPr>
            <a:lvl5pPr marL="1733337" indent="0">
              <a:buNone/>
              <a:defRPr sz="1896"/>
            </a:lvl5pPr>
            <a:lvl6pPr marL="2166671" indent="0">
              <a:buNone/>
              <a:defRPr sz="1896"/>
            </a:lvl6pPr>
            <a:lvl7pPr marL="2600005" indent="0">
              <a:buNone/>
              <a:defRPr sz="1896"/>
            </a:lvl7pPr>
            <a:lvl8pPr marL="3033339" indent="0">
              <a:buNone/>
              <a:defRPr sz="1896"/>
            </a:lvl8pPr>
            <a:lvl9pPr marL="3466673" indent="0">
              <a:buNone/>
              <a:defRPr sz="1896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5940" y="2105977"/>
            <a:ext cx="3726921" cy="3901584"/>
          </a:xfrm>
        </p:spPr>
        <p:txBody>
          <a:bodyPr/>
          <a:lstStyle>
            <a:lvl1pPr marL="0" indent="0">
              <a:buNone/>
              <a:defRPr sz="1516"/>
            </a:lvl1pPr>
            <a:lvl2pPr marL="433334" indent="0">
              <a:buNone/>
              <a:defRPr sz="1327"/>
            </a:lvl2pPr>
            <a:lvl3pPr marL="866668" indent="0">
              <a:buNone/>
              <a:defRPr sz="1137"/>
            </a:lvl3pPr>
            <a:lvl4pPr marL="1300002" indent="0">
              <a:buNone/>
              <a:defRPr sz="948"/>
            </a:lvl4pPr>
            <a:lvl5pPr marL="1733337" indent="0">
              <a:buNone/>
              <a:defRPr sz="948"/>
            </a:lvl5pPr>
            <a:lvl6pPr marL="2166671" indent="0">
              <a:buNone/>
              <a:defRPr sz="948"/>
            </a:lvl6pPr>
            <a:lvl7pPr marL="2600005" indent="0">
              <a:buNone/>
              <a:defRPr sz="948"/>
            </a:lvl7pPr>
            <a:lvl8pPr marL="3033339" indent="0">
              <a:buNone/>
              <a:defRPr sz="948"/>
            </a:lvl8pPr>
            <a:lvl9pPr marL="3466673" indent="0">
              <a:buNone/>
              <a:defRPr sz="948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9699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94435" y="373747"/>
            <a:ext cx="9966544" cy="1356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435" y="1868730"/>
            <a:ext cx="9966544" cy="44540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4435" y="6506431"/>
            <a:ext cx="2599968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B5760-988A-4655-8F78-3B673EC326EE}" type="datetimeFigureOut">
              <a:rPr lang="fr-FR" smtClean="0"/>
              <a:t>13/1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27731" y="6506431"/>
            <a:ext cx="3899952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61010" y="6506431"/>
            <a:ext cx="2599968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5462CA-C86E-4880-AA6E-E0A0697C425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9403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66668" rtl="0" eaLnBrk="1" latinLnBrk="0" hangingPunct="1">
        <a:lnSpc>
          <a:spcPct val="90000"/>
        </a:lnSpc>
        <a:spcBef>
          <a:spcPct val="0"/>
        </a:spcBef>
        <a:buNone/>
        <a:defRPr sz="41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667" indent="-216667" algn="l" defTabSz="866668" rtl="0" eaLnBrk="1" latinLnBrk="0" hangingPunct="1">
        <a:lnSpc>
          <a:spcPct val="90000"/>
        </a:lnSpc>
        <a:spcBef>
          <a:spcPts val="948"/>
        </a:spcBef>
        <a:buFont typeface="Arial" panose="020B0604020202020204" pitchFamily="34" charset="0"/>
        <a:buChar char="•"/>
        <a:defRPr sz="2654" kern="1200">
          <a:solidFill>
            <a:schemeClr val="tx1"/>
          </a:solidFill>
          <a:latin typeface="+mn-lt"/>
          <a:ea typeface="+mn-ea"/>
          <a:cs typeface="+mn-cs"/>
        </a:defRPr>
      </a:lvl1pPr>
      <a:lvl2pPr marL="650001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2275" kern="1200">
          <a:solidFill>
            <a:schemeClr val="tx1"/>
          </a:solidFill>
          <a:latin typeface="+mn-lt"/>
          <a:ea typeface="+mn-ea"/>
          <a:cs typeface="+mn-cs"/>
        </a:defRPr>
      </a:lvl2pPr>
      <a:lvl3pPr marL="1083335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896" kern="1200">
          <a:solidFill>
            <a:schemeClr val="tx1"/>
          </a:solidFill>
          <a:latin typeface="+mn-lt"/>
          <a:ea typeface="+mn-ea"/>
          <a:cs typeface="+mn-cs"/>
        </a:defRPr>
      </a:lvl3pPr>
      <a:lvl4pPr marL="1516670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4pPr>
      <a:lvl5pPr marL="1950004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5pPr>
      <a:lvl6pPr marL="2383338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6pPr>
      <a:lvl7pPr marL="2816672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7pPr>
      <a:lvl8pPr marL="3250006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8pPr>
      <a:lvl9pPr marL="3683340" indent="-216667" algn="l" defTabSz="866668" rtl="0" eaLnBrk="1" latinLnBrk="0" hangingPunct="1">
        <a:lnSpc>
          <a:spcPct val="90000"/>
        </a:lnSpc>
        <a:spcBef>
          <a:spcPts val="474"/>
        </a:spcBef>
        <a:buFont typeface="Arial" panose="020B0604020202020204" pitchFamily="34" charset="0"/>
        <a:buChar char="•"/>
        <a:defRPr sz="17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1pPr>
      <a:lvl2pPr marL="433334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2pPr>
      <a:lvl3pPr marL="866668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3pPr>
      <a:lvl4pPr marL="1300002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4pPr>
      <a:lvl5pPr marL="1733337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5pPr>
      <a:lvl6pPr marL="2166671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6pPr>
      <a:lvl7pPr marL="2600005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7pPr>
      <a:lvl8pPr marL="3033339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8pPr>
      <a:lvl9pPr marL="3466673" algn="l" defTabSz="866668" rtl="0" eaLnBrk="1" latinLnBrk="0" hangingPunct="1">
        <a:defRPr sz="17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ZoneTexte 141">
            <a:extLst>
              <a:ext uri="{FF2B5EF4-FFF2-40B4-BE49-F238E27FC236}">
                <a16:creationId xmlns:a16="http://schemas.microsoft.com/office/drawing/2014/main" id="{8CE2A9FE-AEBA-DF9F-FCDA-59B04C7FEF60}"/>
              </a:ext>
            </a:extLst>
          </p:cNvPr>
          <p:cNvSpPr txBox="1"/>
          <p:nvPr/>
        </p:nvSpPr>
        <p:spPr>
          <a:xfrm>
            <a:off x="2939099" y="605048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6</a:t>
            </a:r>
          </a:p>
        </p:txBody>
      </p:sp>
      <p:sp>
        <p:nvSpPr>
          <p:cNvPr id="143" name="ZoneTexte 142">
            <a:extLst>
              <a:ext uri="{FF2B5EF4-FFF2-40B4-BE49-F238E27FC236}">
                <a16:creationId xmlns:a16="http://schemas.microsoft.com/office/drawing/2014/main" id="{C9C74C70-2B9D-89B0-BDAD-50FCD567F3A1}"/>
              </a:ext>
            </a:extLst>
          </p:cNvPr>
          <p:cNvSpPr txBox="1"/>
          <p:nvPr/>
        </p:nvSpPr>
        <p:spPr>
          <a:xfrm>
            <a:off x="4177479" y="605048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7</a:t>
            </a:r>
          </a:p>
        </p:txBody>
      </p:sp>
      <p:sp>
        <p:nvSpPr>
          <p:cNvPr id="144" name="ZoneTexte 143">
            <a:extLst>
              <a:ext uri="{FF2B5EF4-FFF2-40B4-BE49-F238E27FC236}">
                <a16:creationId xmlns:a16="http://schemas.microsoft.com/office/drawing/2014/main" id="{6372D1A8-6B5A-9138-1141-F67FDCC1652F}"/>
              </a:ext>
            </a:extLst>
          </p:cNvPr>
          <p:cNvSpPr txBox="1"/>
          <p:nvPr/>
        </p:nvSpPr>
        <p:spPr>
          <a:xfrm>
            <a:off x="5410632" y="605048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8</a:t>
            </a:r>
          </a:p>
        </p:txBody>
      </p:sp>
      <p:sp>
        <p:nvSpPr>
          <p:cNvPr id="145" name="ZoneTexte 144">
            <a:extLst>
              <a:ext uri="{FF2B5EF4-FFF2-40B4-BE49-F238E27FC236}">
                <a16:creationId xmlns:a16="http://schemas.microsoft.com/office/drawing/2014/main" id="{3E28E9C1-C9F6-A3B9-22A1-F1EC09C5AB63}"/>
              </a:ext>
            </a:extLst>
          </p:cNvPr>
          <p:cNvSpPr txBox="1"/>
          <p:nvPr/>
        </p:nvSpPr>
        <p:spPr>
          <a:xfrm>
            <a:off x="6648403" y="605048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0</a:t>
            </a:r>
            <a:r>
              <a:rPr lang="en-GB" sz="1200" dirty="0"/>
              <a:t>.</a:t>
            </a:r>
            <a:r>
              <a:rPr lang="fr-FR" sz="1200" dirty="0"/>
              <a:t>9</a:t>
            </a:r>
          </a:p>
        </p:txBody>
      </p:sp>
      <p:sp>
        <p:nvSpPr>
          <p:cNvPr id="146" name="ZoneTexte 145">
            <a:extLst>
              <a:ext uri="{FF2B5EF4-FFF2-40B4-BE49-F238E27FC236}">
                <a16:creationId xmlns:a16="http://schemas.microsoft.com/office/drawing/2014/main" id="{8D2EC4CE-E516-97D0-23D3-4A5A69909006}"/>
              </a:ext>
            </a:extLst>
          </p:cNvPr>
          <p:cNvSpPr txBox="1"/>
          <p:nvPr/>
        </p:nvSpPr>
        <p:spPr>
          <a:xfrm>
            <a:off x="7891515" y="605048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1</a:t>
            </a:r>
            <a:r>
              <a:rPr lang="en-GB" sz="1200" dirty="0"/>
              <a:t>.</a:t>
            </a:r>
            <a:r>
              <a:rPr lang="fr-FR" sz="1200" dirty="0"/>
              <a:t>0</a:t>
            </a:r>
          </a:p>
        </p:txBody>
      </p:sp>
      <p:sp>
        <p:nvSpPr>
          <p:cNvPr id="147" name="ZoneTexte 146">
            <a:extLst>
              <a:ext uri="{FF2B5EF4-FFF2-40B4-BE49-F238E27FC236}">
                <a16:creationId xmlns:a16="http://schemas.microsoft.com/office/drawing/2014/main" id="{142E2878-76EB-07E1-A427-2BC7126C03CA}"/>
              </a:ext>
            </a:extLst>
          </p:cNvPr>
          <p:cNvSpPr txBox="1"/>
          <p:nvPr/>
        </p:nvSpPr>
        <p:spPr>
          <a:xfrm>
            <a:off x="5120983" y="6257882"/>
            <a:ext cx="981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UC (95%CI)</a:t>
            </a:r>
          </a:p>
        </p:txBody>
      </p:sp>
      <p:sp>
        <p:nvSpPr>
          <p:cNvPr id="55" name="Forme libre : forme 54">
            <a:extLst>
              <a:ext uri="{FF2B5EF4-FFF2-40B4-BE49-F238E27FC236}">
                <a16:creationId xmlns:a16="http://schemas.microsoft.com/office/drawing/2014/main" id="{8A5B3853-DC7C-1778-5992-387A85813763}"/>
              </a:ext>
            </a:extLst>
          </p:cNvPr>
          <p:cNvSpPr/>
          <p:nvPr/>
        </p:nvSpPr>
        <p:spPr>
          <a:xfrm>
            <a:off x="2181700" y="855323"/>
            <a:ext cx="12533" cy="5069574"/>
          </a:xfrm>
          <a:custGeom>
            <a:avLst/>
            <a:gdLst>
              <a:gd name="connsiteX0" fmla="*/ 0 w 12694"/>
              <a:gd name="connsiteY0" fmla="*/ 5069574 h 5069574"/>
              <a:gd name="connsiteX1" fmla="*/ 0 w 12694"/>
              <a:gd name="connsiteY1" fmla="*/ 0 h 50695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5069574">
                <a:moveTo>
                  <a:pt x="0" y="5069574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 dirty="0"/>
          </a:p>
        </p:txBody>
      </p:sp>
      <p:sp>
        <p:nvSpPr>
          <p:cNvPr id="95" name="Forme libre : forme 94">
            <a:extLst>
              <a:ext uri="{FF2B5EF4-FFF2-40B4-BE49-F238E27FC236}">
                <a16:creationId xmlns:a16="http://schemas.microsoft.com/office/drawing/2014/main" id="{7195BB41-1C74-CABB-6132-AD56E841DC81}"/>
              </a:ext>
            </a:extLst>
          </p:cNvPr>
          <p:cNvSpPr/>
          <p:nvPr/>
        </p:nvSpPr>
        <p:spPr>
          <a:xfrm>
            <a:off x="2172735" y="5924897"/>
            <a:ext cx="6455800" cy="12692"/>
          </a:xfrm>
          <a:custGeom>
            <a:avLst/>
            <a:gdLst>
              <a:gd name="connsiteX0" fmla="*/ 0 w 6538830"/>
              <a:gd name="connsiteY0" fmla="*/ 0 h 12692"/>
              <a:gd name="connsiteX1" fmla="*/ 6538831 w 6538830"/>
              <a:gd name="connsiteY1" fmla="*/ 0 h 126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6538830" h="12692">
                <a:moveTo>
                  <a:pt x="0" y="0"/>
                </a:moveTo>
                <a:lnTo>
                  <a:pt x="6538831" y="0"/>
                </a:lnTo>
              </a:path>
            </a:pathLst>
          </a:custGeom>
          <a:noFill/>
          <a:ln w="3175" cap="flat">
            <a:solidFill>
              <a:srgbClr val="000000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96" name="Forme libre : forme 95">
            <a:extLst>
              <a:ext uri="{FF2B5EF4-FFF2-40B4-BE49-F238E27FC236}">
                <a16:creationId xmlns:a16="http://schemas.microsoft.com/office/drawing/2014/main" id="{6ADF6539-FA6E-3E6C-0ABE-FEACE056FF57}"/>
              </a:ext>
            </a:extLst>
          </p:cNvPr>
          <p:cNvSpPr/>
          <p:nvPr/>
        </p:nvSpPr>
        <p:spPr>
          <a:xfrm>
            <a:off x="3127981" y="5924897"/>
            <a:ext cx="12533" cy="54000"/>
          </a:xfrm>
          <a:custGeom>
            <a:avLst/>
            <a:gdLst>
              <a:gd name="connsiteX0" fmla="*/ 0 w 12694"/>
              <a:gd name="connsiteY0" fmla="*/ 34753 h 34752"/>
              <a:gd name="connsiteX1" fmla="*/ 0 w 12694"/>
              <a:gd name="connsiteY1" fmla="*/ 0 h 347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34752">
                <a:moveTo>
                  <a:pt x="0" y="3475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97" name="Forme libre : forme 96">
            <a:extLst>
              <a:ext uri="{FF2B5EF4-FFF2-40B4-BE49-F238E27FC236}">
                <a16:creationId xmlns:a16="http://schemas.microsoft.com/office/drawing/2014/main" id="{D3FA0269-A4CA-7FEC-B47F-62E964CE3DF2}"/>
              </a:ext>
            </a:extLst>
          </p:cNvPr>
          <p:cNvSpPr/>
          <p:nvPr/>
        </p:nvSpPr>
        <p:spPr>
          <a:xfrm>
            <a:off x="4367781" y="5924897"/>
            <a:ext cx="12533" cy="54000"/>
          </a:xfrm>
          <a:custGeom>
            <a:avLst/>
            <a:gdLst>
              <a:gd name="connsiteX0" fmla="*/ 0 w 12694"/>
              <a:gd name="connsiteY0" fmla="*/ 34753 h 34752"/>
              <a:gd name="connsiteX1" fmla="*/ 0 w 12694"/>
              <a:gd name="connsiteY1" fmla="*/ 0 h 347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34752">
                <a:moveTo>
                  <a:pt x="0" y="3475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98" name="Forme libre : forme 97">
            <a:extLst>
              <a:ext uri="{FF2B5EF4-FFF2-40B4-BE49-F238E27FC236}">
                <a16:creationId xmlns:a16="http://schemas.microsoft.com/office/drawing/2014/main" id="{A42A61AD-BB3E-F8BE-558E-5D0D48F95A88}"/>
              </a:ext>
            </a:extLst>
          </p:cNvPr>
          <p:cNvSpPr/>
          <p:nvPr/>
        </p:nvSpPr>
        <p:spPr>
          <a:xfrm>
            <a:off x="5607532" y="5924897"/>
            <a:ext cx="12533" cy="54000"/>
          </a:xfrm>
          <a:custGeom>
            <a:avLst/>
            <a:gdLst>
              <a:gd name="connsiteX0" fmla="*/ 0 w 12694"/>
              <a:gd name="connsiteY0" fmla="*/ 34753 h 34752"/>
              <a:gd name="connsiteX1" fmla="*/ 0 w 12694"/>
              <a:gd name="connsiteY1" fmla="*/ 0 h 347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34752">
                <a:moveTo>
                  <a:pt x="0" y="3475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99" name="Forme libre : forme 98">
            <a:extLst>
              <a:ext uri="{FF2B5EF4-FFF2-40B4-BE49-F238E27FC236}">
                <a16:creationId xmlns:a16="http://schemas.microsoft.com/office/drawing/2014/main" id="{63B84168-8508-F834-6125-222BCD94D533}"/>
              </a:ext>
            </a:extLst>
          </p:cNvPr>
          <p:cNvSpPr/>
          <p:nvPr/>
        </p:nvSpPr>
        <p:spPr>
          <a:xfrm>
            <a:off x="6847333" y="5924897"/>
            <a:ext cx="12533" cy="54000"/>
          </a:xfrm>
          <a:custGeom>
            <a:avLst/>
            <a:gdLst>
              <a:gd name="connsiteX0" fmla="*/ 0 w 12694"/>
              <a:gd name="connsiteY0" fmla="*/ 34753 h 34752"/>
              <a:gd name="connsiteX1" fmla="*/ 0 w 12694"/>
              <a:gd name="connsiteY1" fmla="*/ 0 h 347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34752">
                <a:moveTo>
                  <a:pt x="0" y="3475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sp>
        <p:nvSpPr>
          <p:cNvPr id="100" name="Forme libre : forme 99">
            <a:extLst>
              <a:ext uri="{FF2B5EF4-FFF2-40B4-BE49-F238E27FC236}">
                <a16:creationId xmlns:a16="http://schemas.microsoft.com/office/drawing/2014/main" id="{B4EAC779-CD24-7C27-23D3-5F8E0F99ED76}"/>
              </a:ext>
            </a:extLst>
          </p:cNvPr>
          <p:cNvSpPr/>
          <p:nvPr/>
        </p:nvSpPr>
        <p:spPr>
          <a:xfrm>
            <a:off x="8087133" y="5924897"/>
            <a:ext cx="12533" cy="54000"/>
          </a:xfrm>
          <a:custGeom>
            <a:avLst/>
            <a:gdLst>
              <a:gd name="connsiteX0" fmla="*/ 0 w 12694"/>
              <a:gd name="connsiteY0" fmla="*/ 34753 h 34752"/>
              <a:gd name="connsiteX1" fmla="*/ 0 w 12694"/>
              <a:gd name="connsiteY1" fmla="*/ 0 h 347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2694" h="34752">
                <a:moveTo>
                  <a:pt x="0" y="34753"/>
                </a:moveTo>
                <a:lnTo>
                  <a:pt x="0" y="0"/>
                </a:lnTo>
              </a:path>
            </a:pathLst>
          </a:custGeom>
          <a:noFill/>
          <a:ln w="3175" cap="flat">
            <a:solidFill>
              <a:srgbClr val="333333"/>
            </a:solidFill>
            <a:prstDash val="solid"/>
            <a:round/>
          </a:ln>
        </p:spPr>
        <p:txBody>
          <a:bodyPr rtlCol="0" anchor="ctr"/>
          <a:lstStyle/>
          <a:p>
            <a:endParaRPr lang="fr-FR"/>
          </a:p>
        </p:txBody>
      </p:sp>
      <p:grpSp>
        <p:nvGrpSpPr>
          <p:cNvPr id="22" name="Groupe 21">
            <a:extLst>
              <a:ext uri="{FF2B5EF4-FFF2-40B4-BE49-F238E27FC236}">
                <a16:creationId xmlns:a16="http://schemas.microsoft.com/office/drawing/2014/main" id="{D66EC466-7241-40C0-B074-AF0A67C625EF}"/>
              </a:ext>
            </a:extLst>
          </p:cNvPr>
          <p:cNvGrpSpPr/>
          <p:nvPr/>
        </p:nvGrpSpPr>
        <p:grpSpPr>
          <a:xfrm>
            <a:off x="836430" y="5101542"/>
            <a:ext cx="9782799" cy="473399"/>
            <a:chOff x="737815" y="5101542"/>
            <a:chExt cx="9782799" cy="473399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A132673E-E3CE-48A1-9370-F2416DFCDF55}"/>
                </a:ext>
              </a:extLst>
            </p:cNvPr>
            <p:cNvGrpSpPr/>
            <p:nvPr/>
          </p:nvGrpSpPr>
          <p:grpSpPr>
            <a:xfrm>
              <a:off x="737815" y="5199742"/>
              <a:ext cx="5746180" cy="276999"/>
              <a:chOff x="737815" y="5122624"/>
              <a:chExt cx="5746180" cy="276999"/>
            </a:xfrm>
          </p:grpSpPr>
          <p:grpSp>
            <p:nvGrpSpPr>
              <p:cNvPr id="2" name="Groupe 1">
                <a:extLst>
                  <a:ext uri="{FF2B5EF4-FFF2-40B4-BE49-F238E27FC236}">
                    <a16:creationId xmlns:a16="http://schemas.microsoft.com/office/drawing/2014/main" id="{369EFC9F-3ECD-45B2-BDD4-40187488A212}"/>
                  </a:ext>
                </a:extLst>
              </p:cNvPr>
              <p:cNvGrpSpPr/>
              <p:nvPr/>
            </p:nvGrpSpPr>
            <p:grpSpPr>
              <a:xfrm>
                <a:off x="3959310" y="5147322"/>
                <a:ext cx="2524685" cy="227602"/>
                <a:chOff x="3959310" y="5062670"/>
                <a:chExt cx="2524685" cy="227602"/>
              </a:xfrm>
            </p:grpSpPr>
            <p:sp>
              <p:nvSpPr>
                <p:cNvPr id="116" name="Forme libre : forme 115">
                  <a:extLst>
                    <a:ext uri="{FF2B5EF4-FFF2-40B4-BE49-F238E27FC236}">
                      <a16:creationId xmlns:a16="http://schemas.microsoft.com/office/drawing/2014/main" id="{CB0A0172-EEF3-4F98-B1FC-B9C65F822A45}"/>
                    </a:ext>
                  </a:extLst>
                </p:cNvPr>
                <p:cNvSpPr/>
                <p:nvPr/>
              </p:nvSpPr>
              <p:spPr>
                <a:xfrm>
                  <a:off x="5612370" y="5118648"/>
                  <a:ext cx="871625" cy="12692"/>
                </a:xfrm>
                <a:custGeom>
                  <a:avLst/>
                  <a:gdLst>
                    <a:gd name="connsiteX0" fmla="*/ 0 w 882835"/>
                    <a:gd name="connsiteY0" fmla="*/ 0 h 12692"/>
                    <a:gd name="connsiteX1" fmla="*/ 882836 w 882835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882835" h="12692">
                      <a:moveTo>
                        <a:pt x="0" y="0"/>
                      </a:moveTo>
                      <a:lnTo>
                        <a:pt x="882836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7" name="Forme libre : forme 116">
                  <a:extLst>
                    <a:ext uri="{FF2B5EF4-FFF2-40B4-BE49-F238E27FC236}">
                      <a16:creationId xmlns:a16="http://schemas.microsoft.com/office/drawing/2014/main" id="{60D8171B-A597-4AB3-AF03-6F3E2261AA73}"/>
                    </a:ext>
                  </a:extLst>
                </p:cNvPr>
                <p:cNvSpPr/>
                <p:nvPr/>
              </p:nvSpPr>
              <p:spPr>
                <a:xfrm>
                  <a:off x="3959310" y="5234294"/>
                  <a:ext cx="1109663" cy="12692"/>
                </a:xfrm>
                <a:custGeom>
                  <a:avLst/>
                  <a:gdLst>
                    <a:gd name="connsiteX0" fmla="*/ 0 w 1123935"/>
                    <a:gd name="connsiteY0" fmla="*/ 0 h 12692"/>
                    <a:gd name="connsiteX1" fmla="*/ 1123936 w 1123935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123935" h="12692">
                      <a:moveTo>
                        <a:pt x="0" y="0"/>
                      </a:moveTo>
                      <a:lnTo>
                        <a:pt x="1123936" y="0"/>
                      </a:lnTo>
                    </a:path>
                  </a:pathLst>
                </a:custGeom>
                <a:noFill/>
                <a:ln w="952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8" name="Forme libre : forme 117">
                  <a:extLst>
                    <a:ext uri="{FF2B5EF4-FFF2-40B4-BE49-F238E27FC236}">
                      <a16:creationId xmlns:a16="http://schemas.microsoft.com/office/drawing/2014/main" id="{2393436C-C281-4F3B-9D03-04B82F681926}"/>
                    </a:ext>
                  </a:extLst>
                </p:cNvPr>
                <p:cNvSpPr/>
                <p:nvPr/>
              </p:nvSpPr>
              <p:spPr>
                <a:xfrm>
                  <a:off x="5992928" y="5062670"/>
                  <a:ext cx="110558" cy="111955"/>
                </a:xfrm>
                <a:custGeom>
                  <a:avLst/>
                  <a:gdLst>
                    <a:gd name="connsiteX0" fmla="*/ 0 w 111980"/>
                    <a:gd name="connsiteY0" fmla="*/ 111955 h 111955"/>
                    <a:gd name="connsiteX1" fmla="*/ 111981 w 111980"/>
                    <a:gd name="connsiteY1" fmla="*/ 111955 h 111955"/>
                    <a:gd name="connsiteX2" fmla="*/ 111981 w 111980"/>
                    <a:gd name="connsiteY2" fmla="*/ 0 h 111955"/>
                    <a:gd name="connsiteX3" fmla="*/ 0 w 111980"/>
                    <a:gd name="connsiteY3" fmla="*/ 0 h 11195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0" h="111955">
                      <a:moveTo>
                        <a:pt x="0" y="111955"/>
                      </a:moveTo>
                      <a:lnTo>
                        <a:pt x="111981" y="111955"/>
                      </a:lnTo>
                      <a:lnTo>
                        <a:pt x="11198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9" name="Forme libre : forme 118">
                  <a:extLst>
                    <a:ext uri="{FF2B5EF4-FFF2-40B4-BE49-F238E27FC236}">
                      <a16:creationId xmlns:a16="http://schemas.microsoft.com/office/drawing/2014/main" id="{3C3C41E6-96E5-4F10-A892-3AD7E3215B17}"/>
                    </a:ext>
                  </a:extLst>
                </p:cNvPr>
                <p:cNvSpPr/>
                <p:nvPr/>
              </p:nvSpPr>
              <p:spPr>
                <a:xfrm>
                  <a:off x="4458888" y="5178318"/>
                  <a:ext cx="110546" cy="111954"/>
                </a:xfrm>
                <a:custGeom>
                  <a:avLst/>
                  <a:gdLst>
                    <a:gd name="connsiteX0" fmla="*/ 0 w 111968"/>
                    <a:gd name="connsiteY0" fmla="*/ 111954 h 111954"/>
                    <a:gd name="connsiteX1" fmla="*/ 111968 w 111968"/>
                    <a:gd name="connsiteY1" fmla="*/ 111954 h 111954"/>
                    <a:gd name="connsiteX2" fmla="*/ 111968 w 111968"/>
                    <a:gd name="connsiteY2" fmla="*/ 0 h 111954"/>
                    <a:gd name="connsiteX3" fmla="*/ 0 w 111968"/>
                    <a:gd name="connsiteY3" fmla="*/ 0 h 1119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68" h="111954">
                      <a:moveTo>
                        <a:pt x="0" y="111954"/>
                      </a:moveTo>
                      <a:lnTo>
                        <a:pt x="111968" y="111954"/>
                      </a:lnTo>
                      <a:lnTo>
                        <a:pt x="111968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17993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12" name="Groupe 11">
                <a:extLst>
                  <a:ext uri="{FF2B5EF4-FFF2-40B4-BE49-F238E27FC236}">
                    <a16:creationId xmlns:a16="http://schemas.microsoft.com/office/drawing/2014/main" id="{6A1DA0D0-0A9F-4495-BD71-C80CF277E9F9}"/>
                  </a:ext>
                </a:extLst>
              </p:cNvPr>
              <p:cNvGrpSpPr/>
              <p:nvPr/>
            </p:nvGrpSpPr>
            <p:grpSpPr>
              <a:xfrm>
                <a:off x="737815" y="5122624"/>
                <a:ext cx="1339875" cy="276999"/>
                <a:chOff x="746778" y="5182578"/>
                <a:chExt cx="1339875" cy="276999"/>
              </a:xfrm>
            </p:grpSpPr>
            <p:sp>
              <p:nvSpPr>
                <p:cNvPr id="120" name="Forme libre : forme 119">
                  <a:extLst>
                    <a:ext uri="{FF2B5EF4-FFF2-40B4-BE49-F238E27FC236}">
                      <a16:creationId xmlns:a16="http://schemas.microsoft.com/office/drawing/2014/main" id="{84F46118-C5B0-43F1-9258-1075F72BEDDB}"/>
                    </a:ext>
                  </a:extLst>
                </p:cNvPr>
                <p:cNvSpPr/>
                <p:nvPr/>
              </p:nvSpPr>
              <p:spPr>
                <a:xfrm>
                  <a:off x="2032653" y="5314727"/>
                  <a:ext cx="54000" cy="12700"/>
                </a:xfrm>
                <a:custGeom>
                  <a:avLst/>
                  <a:gdLst>
                    <a:gd name="connsiteX0" fmla="*/ 0 w 34772"/>
                    <a:gd name="connsiteY0" fmla="*/ 0 h 12700"/>
                    <a:gd name="connsiteX1" fmla="*/ 34773 w 34772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4772" h="12700">
                      <a:moveTo>
                        <a:pt x="0" y="0"/>
                      </a:moveTo>
                      <a:lnTo>
                        <a:pt x="34773" y="0"/>
                      </a:lnTo>
                    </a:path>
                  </a:pathLst>
                </a:custGeom>
                <a:noFill/>
                <a:ln w="3175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21" name="ZoneTexte 120">
                  <a:extLst>
                    <a:ext uri="{FF2B5EF4-FFF2-40B4-BE49-F238E27FC236}">
                      <a16:creationId xmlns:a16="http://schemas.microsoft.com/office/drawing/2014/main" id="{5BEA9879-6E5E-4540-BC05-8A1195347F64}"/>
                    </a:ext>
                  </a:extLst>
                </p:cNvPr>
                <p:cNvSpPr txBox="1"/>
                <p:nvPr/>
              </p:nvSpPr>
              <p:spPr>
                <a:xfrm>
                  <a:off x="746778" y="5182578"/>
                  <a:ext cx="13359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200" dirty="0"/>
                    <a:t>All virus </a:t>
                  </a:r>
                  <a:r>
                    <a:rPr lang="fr-FR" sz="1200" dirty="0" err="1"/>
                    <a:t>combined</a:t>
                  </a:r>
                  <a:endParaRPr lang="fr-FR" sz="1200" dirty="0"/>
                </a:p>
              </p:txBody>
            </p:sp>
          </p:grpSp>
        </p:grpSp>
        <p:grpSp>
          <p:nvGrpSpPr>
            <p:cNvPr id="61" name="Groupe 60">
              <a:extLst>
                <a:ext uri="{FF2B5EF4-FFF2-40B4-BE49-F238E27FC236}">
                  <a16:creationId xmlns:a16="http://schemas.microsoft.com/office/drawing/2014/main" id="{6BE87EBB-A5A7-4482-8E82-B5FEE37C58C5}"/>
                </a:ext>
              </a:extLst>
            </p:cNvPr>
            <p:cNvGrpSpPr/>
            <p:nvPr/>
          </p:nvGrpSpPr>
          <p:grpSpPr>
            <a:xfrm>
              <a:off x="8431816" y="5101542"/>
              <a:ext cx="2088798" cy="473399"/>
              <a:chOff x="8848725" y="5118720"/>
              <a:chExt cx="2088798" cy="473399"/>
            </a:xfrm>
          </p:grpSpPr>
          <p:grpSp>
            <p:nvGrpSpPr>
              <p:cNvPr id="59" name="Groupe 58">
                <a:extLst>
                  <a:ext uri="{FF2B5EF4-FFF2-40B4-BE49-F238E27FC236}">
                    <a16:creationId xmlns:a16="http://schemas.microsoft.com/office/drawing/2014/main" id="{B8A9EA50-14E7-4640-8891-23C455A36F37}"/>
                  </a:ext>
                </a:extLst>
              </p:cNvPr>
              <p:cNvGrpSpPr/>
              <p:nvPr/>
            </p:nvGrpSpPr>
            <p:grpSpPr>
              <a:xfrm>
                <a:off x="8848725" y="5135036"/>
                <a:ext cx="132592" cy="440767"/>
                <a:chOff x="6115050" y="5135827"/>
                <a:chExt cx="132592" cy="501637"/>
              </a:xfrm>
            </p:grpSpPr>
            <p:sp>
              <p:nvSpPr>
                <p:cNvPr id="122" name="Forme libre : forme 121">
                  <a:extLst>
                    <a:ext uri="{FF2B5EF4-FFF2-40B4-BE49-F238E27FC236}">
                      <a16:creationId xmlns:a16="http://schemas.microsoft.com/office/drawing/2014/main" id="{8432AFDD-108C-4784-9D0C-5FFD0C329CB8}"/>
                    </a:ext>
                  </a:extLst>
                </p:cNvPr>
                <p:cNvSpPr/>
                <p:nvPr/>
              </p:nvSpPr>
              <p:spPr>
                <a:xfrm>
                  <a:off x="6115050" y="5624772"/>
                  <a:ext cx="120996" cy="12692"/>
                </a:xfrm>
                <a:custGeom>
                  <a:avLst/>
                  <a:gdLst>
                    <a:gd name="connsiteX0" fmla="*/ 0 w 178362"/>
                    <a:gd name="connsiteY0" fmla="*/ 0 h 12692"/>
                    <a:gd name="connsiteX1" fmla="*/ 178362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0" y="0"/>
                      </a:moveTo>
                      <a:lnTo>
                        <a:pt x="178362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23" name="Forme libre : forme 122">
                  <a:extLst>
                    <a:ext uri="{FF2B5EF4-FFF2-40B4-BE49-F238E27FC236}">
                      <a16:creationId xmlns:a16="http://schemas.microsoft.com/office/drawing/2014/main" id="{1D131DD5-9701-4BEA-B4A3-7D181FBAC073}"/>
                    </a:ext>
                  </a:extLst>
                </p:cNvPr>
                <p:cNvSpPr/>
                <p:nvPr/>
              </p:nvSpPr>
              <p:spPr>
                <a:xfrm>
                  <a:off x="6234948" y="5135827"/>
                  <a:ext cx="12694" cy="487431"/>
                </a:xfrm>
                <a:custGeom>
                  <a:avLst/>
                  <a:gdLst>
                    <a:gd name="connsiteX0" fmla="*/ 0 w 12694"/>
                    <a:gd name="connsiteY0" fmla="*/ 487432 h 487431"/>
                    <a:gd name="connsiteX1" fmla="*/ 0 w 12694"/>
                    <a:gd name="connsiteY1" fmla="*/ 0 h 48743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694" h="487431">
                      <a:moveTo>
                        <a:pt x="0" y="487432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24" name="Forme libre : forme 123">
                  <a:extLst>
                    <a:ext uri="{FF2B5EF4-FFF2-40B4-BE49-F238E27FC236}">
                      <a16:creationId xmlns:a16="http://schemas.microsoft.com/office/drawing/2014/main" id="{6555FA6A-6EE9-43FC-B4BF-62FC0483E26E}"/>
                    </a:ext>
                  </a:extLst>
                </p:cNvPr>
                <p:cNvSpPr/>
                <p:nvPr/>
              </p:nvSpPr>
              <p:spPr>
                <a:xfrm>
                  <a:off x="6115050" y="5137340"/>
                  <a:ext cx="120996" cy="12692"/>
                </a:xfrm>
                <a:custGeom>
                  <a:avLst/>
                  <a:gdLst>
                    <a:gd name="connsiteX0" fmla="*/ 178362 w 178362"/>
                    <a:gd name="connsiteY0" fmla="*/ 0 h 12692"/>
                    <a:gd name="connsiteX1" fmla="*/ 0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178362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60" name="Groupe 59">
                <a:extLst>
                  <a:ext uri="{FF2B5EF4-FFF2-40B4-BE49-F238E27FC236}">
                    <a16:creationId xmlns:a16="http://schemas.microsoft.com/office/drawing/2014/main" id="{892BD6B4-AF1B-4B23-ACAE-860613D9B72B}"/>
                  </a:ext>
                </a:extLst>
              </p:cNvPr>
              <p:cNvGrpSpPr/>
              <p:nvPr/>
            </p:nvGrpSpPr>
            <p:grpSpPr>
              <a:xfrm>
                <a:off x="8979936" y="5118720"/>
                <a:ext cx="1957587" cy="473399"/>
                <a:chOff x="6185936" y="5141028"/>
                <a:chExt cx="1957587" cy="473399"/>
              </a:xfrm>
            </p:grpSpPr>
            <p:sp>
              <p:nvSpPr>
                <p:cNvPr id="126" name="ZoneTexte 125">
                  <a:extLst>
                    <a:ext uri="{FF2B5EF4-FFF2-40B4-BE49-F238E27FC236}">
                      <a16:creationId xmlns:a16="http://schemas.microsoft.com/office/drawing/2014/main" id="{9310E8FB-89C8-4A26-BD17-2279118138A3}"/>
                    </a:ext>
                  </a:extLst>
                </p:cNvPr>
                <p:cNvSpPr txBox="1"/>
                <p:nvPr/>
              </p:nvSpPr>
              <p:spPr>
                <a:xfrm>
                  <a:off x="6185936" y="5141028"/>
                  <a:ext cx="65114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i="1" dirty="0">
                      <a:cs typeface="Times New Roman" panose="02020603050405020304" pitchFamily="18" charset="0"/>
                    </a:rPr>
                    <a:t>&lt;0</a:t>
                  </a:r>
                  <a:r>
                    <a:rPr lang="en-GB" sz="1100" i="1" dirty="0">
                      <a:cs typeface="Times New Roman" panose="02020603050405020304" pitchFamily="18" charset="0"/>
                    </a:rPr>
                    <a:t>.</a:t>
                  </a:r>
                  <a:r>
                    <a:rPr lang="en-GB" sz="1100" i="1" dirty="0">
                      <a:ea typeface="Times New Roman" panose="02020603050405020304" pitchFamily="18" charset="0"/>
                    </a:rPr>
                    <a:t>0001</a:t>
                  </a:r>
                  <a:endParaRPr lang="fr-FR" sz="1100" i="1" dirty="0"/>
                </a:p>
              </p:txBody>
            </p:sp>
            <p:sp>
              <p:nvSpPr>
                <p:cNvPr id="127" name="ZoneTexte 126">
                  <a:extLst>
                    <a:ext uri="{FF2B5EF4-FFF2-40B4-BE49-F238E27FC236}">
                      <a16:creationId xmlns:a16="http://schemas.microsoft.com/office/drawing/2014/main" id="{22B7E908-6033-48B3-845D-ADA3D810E571}"/>
                    </a:ext>
                  </a:extLst>
                </p:cNvPr>
                <p:cNvSpPr txBox="1"/>
                <p:nvPr/>
              </p:nvSpPr>
              <p:spPr>
                <a:xfrm>
                  <a:off x="6185936" y="5352817"/>
                  <a:ext cx="19575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dirty="0">
                      <a:cs typeface="Times New Roman" panose="02020603050405020304" pitchFamily="18" charset="0"/>
                    </a:rPr>
                    <a:t>MD (95%CI):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(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77-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7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)</a:t>
                  </a:r>
                  <a:endParaRPr lang="fr-FR" sz="1100" dirty="0"/>
                </a:p>
              </p:txBody>
            </p:sp>
          </p:grpSp>
        </p:grpSp>
      </p:grp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97BC6E67-89A1-497E-BF33-41DC887ED167}"/>
              </a:ext>
            </a:extLst>
          </p:cNvPr>
          <p:cNvGrpSpPr/>
          <p:nvPr/>
        </p:nvGrpSpPr>
        <p:grpSpPr>
          <a:xfrm>
            <a:off x="1774583" y="4126570"/>
            <a:ext cx="9010988" cy="500133"/>
            <a:chOff x="1675968" y="4117393"/>
            <a:chExt cx="9010988" cy="500133"/>
          </a:xfrm>
        </p:grpSpPr>
        <p:grpSp>
          <p:nvGrpSpPr>
            <p:cNvPr id="16" name="Groupe 15">
              <a:extLst>
                <a:ext uri="{FF2B5EF4-FFF2-40B4-BE49-F238E27FC236}">
                  <a16:creationId xmlns:a16="http://schemas.microsoft.com/office/drawing/2014/main" id="{8D3B6D8C-E8D3-49BE-ADB1-BB0D747C20C2}"/>
                </a:ext>
              </a:extLst>
            </p:cNvPr>
            <p:cNvGrpSpPr/>
            <p:nvPr/>
          </p:nvGrpSpPr>
          <p:grpSpPr>
            <a:xfrm>
              <a:off x="1675968" y="4228960"/>
              <a:ext cx="5000542" cy="276999"/>
              <a:chOff x="1675968" y="4128684"/>
              <a:chExt cx="5000542" cy="276999"/>
            </a:xfrm>
          </p:grpSpPr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E3B1F343-FC9D-4136-A00C-21E9F6AB3CF2}"/>
                  </a:ext>
                </a:extLst>
              </p:cNvPr>
              <p:cNvGrpSpPr/>
              <p:nvPr/>
            </p:nvGrpSpPr>
            <p:grpSpPr>
              <a:xfrm>
                <a:off x="3498199" y="4134390"/>
                <a:ext cx="3178311" cy="265586"/>
                <a:chOff x="3498199" y="4071338"/>
                <a:chExt cx="3178311" cy="265586"/>
              </a:xfrm>
            </p:grpSpPr>
            <p:sp>
              <p:nvSpPr>
                <p:cNvPr id="109" name="Forme libre : forme 108">
                  <a:extLst>
                    <a:ext uri="{FF2B5EF4-FFF2-40B4-BE49-F238E27FC236}">
                      <a16:creationId xmlns:a16="http://schemas.microsoft.com/office/drawing/2014/main" id="{93254E06-4134-4A0E-91C1-AC741F1F2D59}"/>
                    </a:ext>
                  </a:extLst>
                </p:cNvPr>
                <p:cNvSpPr/>
                <p:nvPr/>
              </p:nvSpPr>
              <p:spPr>
                <a:xfrm>
                  <a:off x="4810957" y="4127326"/>
                  <a:ext cx="1865553" cy="12692"/>
                </a:xfrm>
                <a:custGeom>
                  <a:avLst/>
                  <a:gdLst>
                    <a:gd name="connsiteX0" fmla="*/ 0 w 1889547"/>
                    <a:gd name="connsiteY0" fmla="*/ 0 h 12692"/>
                    <a:gd name="connsiteX1" fmla="*/ 1889548 w 1889547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889547" h="12692">
                      <a:moveTo>
                        <a:pt x="0" y="0"/>
                      </a:moveTo>
                      <a:lnTo>
                        <a:pt x="1889548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0" name="Forme libre : forme 109">
                  <a:extLst>
                    <a:ext uri="{FF2B5EF4-FFF2-40B4-BE49-F238E27FC236}">
                      <a16:creationId xmlns:a16="http://schemas.microsoft.com/office/drawing/2014/main" id="{B402176B-46B2-43D7-BC04-DE4AB7031BEC}"/>
                    </a:ext>
                  </a:extLst>
                </p:cNvPr>
                <p:cNvSpPr/>
                <p:nvPr/>
              </p:nvSpPr>
              <p:spPr>
                <a:xfrm>
                  <a:off x="3498199" y="4280949"/>
                  <a:ext cx="2205039" cy="12692"/>
                </a:xfrm>
                <a:custGeom>
                  <a:avLst/>
                  <a:gdLst>
                    <a:gd name="connsiteX0" fmla="*/ 0 w 2233399"/>
                    <a:gd name="connsiteY0" fmla="*/ 0 h 12692"/>
                    <a:gd name="connsiteX1" fmla="*/ 2233400 w 2233399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233399" h="12692">
                      <a:moveTo>
                        <a:pt x="0" y="0"/>
                      </a:moveTo>
                      <a:lnTo>
                        <a:pt x="2233400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1" name="Forme libre : forme 110">
                  <a:extLst>
                    <a:ext uri="{FF2B5EF4-FFF2-40B4-BE49-F238E27FC236}">
                      <a16:creationId xmlns:a16="http://schemas.microsoft.com/office/drawing/2014/main" id="{70971359-07F7-4444-9FD4-A4217E10C103}"/>
                    </a:ext>
                  </a:extLst>
                </p:cNvPr>
                <p:cNvSpPr/>
                <p:nvPr/>
              </p:nvSpPr>
              <p:spPr>
                <a:xfrm>
                  <a:off x="5688449" y="4071338"/>
                  <a:ext cx="110558" cy="111962"/>
                </a:xfrm>
                <a:custGeom>
                  <a:avLst/>
                  <a:gdLst>
                    <a:gd name="connsiteX0" fmla="*/ 0 w 111980"/>
                    <a:gd name="connsiteY0" fmla="*/ 111963 h 111962"/>
                    <a:gd name="connsiteX1" fmla="*/ 111981 w 111980"/>
                    <a:gd name="connsiteY1" fmla="*/ 111963 h 111962"/>
                    <a:gd name="connsiteX2" fmla="*/ 111981 w 111980"/>
                    <a:gd name="connsiteY2" fmla="*/ 0 h 111962"/>
                    <a:gd name="connsiteX3" fmla="*/ 0 w 111980"/>
                    <a:gd name="connsiteY3" fmla="*/ 0 h 11196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0" h="111962">
                      <a:moveTo>
                        <a:pt x="0" y="111963"/>
                      </a:moveTo>
                      <a:lnTo>
                        <a:pt x="111981" y="111963"/>
                      </a:lnTo>
                      <a:lnTo>
                        <a:pt x="11198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2" name="Forme libre : forme 111">
                  <a:extLst>
                    <a:ext uri="{FF2B5EF4-FFF2-40B4-BE49-F238E27FC236}">
                      <a16:creationId xmlns:a16="http://schemas.microsoft.com/office/drawing/2014/main" id="{E359A347-D151-47E5-BACA-BC7F60C52155}"/>
                    </a:ext>
                  </a:extLst>
                </p:cNvPr>
                <p:cNvSpPr/>
                <p:nvPr/>
              </p:nvSpPr>
              <p:spPr>
                <a:xfrm>
                  <a:off x="4545445" y="4224974"/>
                  <a:ext cx="110558" cy="111950"/>
                </a:xfrm>
                <a:custGeom>
                  <a:avLst/>
                  <a:gdLst>
                    <a:gd name="connsiteX0" fmla="*/ 0 w 111980"/>
                    <a:gd name="connsiteY0" fmla="*/ 111950 h 111950"/>
                    <a:gd name="connsiteX1" fmla="*/ 111981 w 111980"/>
                    <a:gd name="connsiteY1" fmla="*/ 111950 h 111950"/>
                    <a:gd name="connsiteX2" fmla="*/ 111981 w 111980"/>
                    <a:gd name="connsiteY2" fmla="*/ 0 h 111950"/>
                    <a:gd name="connsiteX3" fmla="*/ 0 w 111980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0" h="111950">
                      <a:moveTo>
                        <a:pt x="0" y="111950"/>
                      </a:moveTo>
                      <a:lnTo>
                        <a:pt x="111981" y="111950"/>
                      </a:lnTo>
                      <a:lnTo>
                        <a:pt x="11198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11" name="Groupe 10">
                <a:extLst>
                  <a:ext uri="{FF2B5EF4-FFF2-40B4-BE49-F238E27FC236}">
                    <a16:creationId xmlns:a16="http://schemas.microsoft.com/office/drawing/2014/main" id="{57A0208A-D6E0-4534-8B01-C12827E685E3}"/>
                  </a:ext>
                </a:extLst>
              </p:cNvPr>
              <p:cNvGrpSpPr/>
              <p:nvPr/>
            </p:nvGrpSpPr>
            <p:grpSpPr>
              <a:xfrm>
                <a:off x="1675968" y="4128684"/>
                <a:ext cx="401722" cy="276999"/>
                <a:chOff x="1684931" y="4186030"/>
                <a:chExt cx="401722" cy="276999"/>
              </a:xfrm>
            </p:grpSpPr>
            <p:sp>
              <p:nvSpPr>
                <p:cNvPr id="113" name="Forme libre : forme 112">
                  <a:extLst>
                    <a:ext uri="{FF2B5EF4-FFF2-40B4-BE49-F238E27FC236}">
                      <a16:creationId xmlns:a16="http://schemas.microsoft.com/office/drawing/2014/main" id="{44BBAC33-0C49-4110-80C1-E5CD447A603E}"/>
                    </a:ext>
                  </a:extLst>
                </p:cNvPr>
                <p:cNvSpPr/>
                <p:nvPr/>
              </p:nvSpPr>
              <p:spPr>
                <a:xfrm>
                  <a:off x="2032653" y="4318179"/>
                  <a:ext cx="54000" cy="12700"/>
                </a:xfrm>
                <a:custGeom>
                  <a:avLst/>
                  <a:gdLst>
                    <a:gd name="connsiteX0" fmla="*/ 0 w 34772"/>
                    <a:gd name="connsiteY0" fmla="*/ 0 h 12700"/>
                    <a:gd name="connsiteX1" fmla="*/ 34773 w 34772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4772" h="12700">
                      <a:moveTo>
                        <a:pt x="0" y="0"/>
                      </a:moveTo>
                      <a:lnTo>
                        <a:pt x="34773" y="0"/>
                      </a:lnTo>
                    </a:path>
                  </a:pathLst>
                </a:custGeom>
                <a:noFill/>
                <a:ln w="3175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14" name="ZoneTexte 113">
                  <a:extLst>
                    <a:ext uri="{FF2B5EF4-FFF2-40B4-BE49-F238E27FC236}">
                      <a16:creationId xmlns:a16="http://schemas.microsoft.com/office/drawing/2014/main" id="{45CE92DD-5C3B-48CA-BE32-7835905DFCA4}"/>
                    </a:ext>
                  </a:extLst>
                </p:cNvPr>
                <p:cNvSpPr txBox="1"/>
                <p:nvPr/>
              </p:nvSpPr>
              <p:spPr>
                <a:xfrm>
                  <a:off x="1684931" y="4186030"/>
                  <a:ext cx="3928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200" dirty="0"/>
                    <a:t>IAV</a:t>
                  </a:r>
                </a:p>
              </p:txBody>
            </p:sp>
          </p:grpSp>
        </p:grpSp>
        <p:grpSp>
          <p:nvGrpSpPr>
            <p:cNvPr id="21" name="Groupe 20">
              <a:extLst>
                <a:ext uri="{FF2B5EF4-FFF2-40B4-BE49-F238E27FC236}">
                  <a16:creationId xmlns:a16="http://schemas.microsoft.com/office/drawing/2014/main" id="{5DA0D8A3-7542-4B90-AE09-29F59EAF4279}"/>
                </a:ext>
              </a:extLst>
            </p:cNvPr>
            <p:cNvGrpSpPr/>
            <p:nvPr/>
          </p:nvGrpSpPr>
          <p:grpSpPr>
            <a:xfrm>
              <a:off x="8438013" y="4117393"/>
              <a:ext cx="2248943" cy="500133"/>
              <a:chOff x="8438013" y="4117393"/>
              <a:chExt cx="2248943" cy="500133"/>
            </a:xfrm>
          </p:grpSpPr>
          <p:grpSp>
            <p:nvGrpSpPr>
              <p:cNvPr id="63" name="Groupe 62">
                <a:extLst>
                  <a:ext uri="{FF2B5EF4-FFF2-40B4-BE49-F238E27FC236}">
                    <a16:creationId xmlns:a16="http://schemas.microsoft.com/office/drawing/2014/main" id="{F41ED3BD-95A6-4E83-A632-94518AACCBB5}"/>
                  </a:ext>
                </a:extLst>
              </p:cNvPr>
              <p:cNvGrpSpPr/>
              <p:nvPr/>
            </p:nvGrpSpPr>
            <p:grpSpPr>
              <a:xfrm>
                <a:off x="8438013" y="4117393"/>
                <a:ext cx="132592" cy="500133"/>
                <a:chOff x="8854922" y="4134571"/>
                <a:chExt cx="132592" cy="500133"/>
              </a:xfrm>
            </p:grpSpPr>
            <p:sp>
              <p:nvSpPr>
                <p:cNvPr id="128" name="Forme libre : forme 127">
                  <a:extLst>
                    <a:ext uri="{FF2B5EF4-FFF2-40B4-BE49-F238E27FC236}">
                      <a16:creationId xmlns:a16="http://schemas.microsoft.com/office/drawing/2014/main" id="{7604E261-66C8-4298-ADB4-078078439813}"/>
                    </a:ext>
                  </a:extLst>
                </p:cNvPr>
                <p:cNvSpPr/>
                <p:nvPr/>
              </p:nvSpPr>
              <p:spPr>
                <a:xfrm>
                  <a:off x="8854922" y="4622012"/>
                  <a:ext cx="120996" cy="12692"/>
                </a:xfrm>
                <a:custGeom>
                  <a:avLst/>
                  <a:gdLst>
                    <a:gd name="connsiteX0" fmla="*/ 0 w 178362"/>
                    <a:gd name="connsiteY0" fmla="*/ 0 h 12692"/>
                    <a:gd name="connsiteX1" fmla="*/ 178362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0" y="0"/>
                      </a:moveTo>
                      <a:lnTo>
                        <a:pt x="178362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29" name="Forme libre : forme 128">
                  <a:extLst>
                    <a:ext uri="{FF2B5EF4-FFF2-40B4-BE49-F238E27FC236}">
                      <a16:creationId xmlns:a16="http://schemas.microsoft.com/office/drawing/2014/main" id="{4AACA5C4-CE70-468F-8D8F-1594E5B6CDA8}"/>
                    </a:ext>
                  </a:extLst>
                </p:cNvPr>
                <p:cNvSpPr/>
                <p:nvPr/>
              </p:nvSpPr>
              <p:spPr>
                <a:xfrm>
                  <a:off x="8974820" y="4134571"/>
                  <a:ext cx="12694" cy="487440"/>
                </a:xfrm>
                <a:custGeom>
                  <a:avLst/>
                  <a:gdLst>
                    <a:gd name="connsiteX0" fmla="*/ 0 w 12694"/>
                    <a:gd name="connsiteY0" fmla="*/ 487440 h 487440"/>
                    <a:gd name="connsiteX1" fmla="*/ 0 w 12694"/>
                    <a:gd name="connsiteY1" fmla="*/ 0 h 4874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694" h="487440">
                      <a:moveTo>
                        <a:pt x="0" y="48744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30" name="Forme libre : forme 129">
                  <a:extLst>
                    <a:ext uri="{FF2B5EF4-FFF2-40B4-BE49-F238E27FC236}">
                      <a16:creationId xmlns:a16="http://schemas.microsoft.com/office/drawing/2014/main" id="{FCCDC993-18A6-4EE8-986C-70B092B92C7A}"/>
                    </a:ext>
                  </a:extLst>
                </p:cNvPr>
                <p:cNvSpPr/>
                <p:nvPr/>
              </p:nvSpPr>
              <p:spPr>
                <a:xfrm>
                  <a:off x="8854922" y="4134571"/>
                  <a:ext cx="120996" cy="12692"/>
                </a:xfrm>
                <a:custGeom>
                  <a:avLst/>
                  <a:gdLst>
                    <a:gd name="connsiteX0" fmla="*/ 178362 w 178362"/>
                    <a:gd name="connsiteY0" fmla="*/ 0 h 12692"/>
                    <a:gd name="connsiteX1" fmla="*/ 0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178362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62" name="Groupe 61">
                <a:extLst>
                  <a:ext uri="{FF2B5EF4-FFF2-40B4-BE49-F238E27FC236}">
                    <a16:creationId xmlns:a16="http://schemas.microsoft.com/office/drawing/2014/main" id="{95F2E5E4-12E7-4CA0-8DDC-BE2097745CC8}"/>
                  </a:ext>
                </a:extLst>
              </p:cNvPr>
              <p:cNvGrpSpPr/>
              <p:nvPr/>
            </p:nvGrpSpPr>
            <p:grpSpPr>
              <a:xfrm>
                <a:off x="8574711" y="4149178"/>
                <a:ext cx="2112245" cy="436562"/>
                <a:chOff x="8915420" y="4141407"/>
                <a:chExt cx="2112245" cy="436562"/>
              </a:xfrm>
            </p:grpSpPr>
            <p:sp>
              <p:nvSpPr>
                <p:cNvPr id="137" name="ZoneTexte 136">
                  <a:extLst>
                    <a:ext uri="{FF2B5EF4-FFF2-40B4-BE49-F238E27FC236}">
                      <a16:creationId xmlns:a16="http://schemas.microsoft.com/office/drawing/2014/main" id="{BCE5E8C3-484E-461E-8877-4126101935A0}"/>
                    </a:ext>
                  </a:extLst>
                </p:cNvPr>
                <p:cNvSpPr txBox="1"/>
                <p:nvPr/>
              </p:nvSpPr>
              <p:spPr>
                <a:xfrm>
                  <a:off x="8915420" y="4141407"/>
                  <a:ext cx="50847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i="1" dirty="0">
                      <a:cs typeface="Times New Roman" panose="02020603050405020304" pitchFamily="18" charset="0"/>
                    </a:rPr>
                    <a:t>0</a:t>
                  </a:r>
                  <a:r>
                    <a:rPr lang="en-GB" sz="1100" i="1" dirty="0">
                      <a:cs typeface="Times New Roman" panose="02020603050405020304" pitchFamily="18" charset="0"/>
                    </a:rPr>
                    <a:t>.</a:t>
                  </a:r>
                  <a:r>
                    <a:rPr lang="en-GB" sz="1100" i="1" dirty="0">
                      <a:ea typeface="Times New Roman" panose="02020603050405020304" pitchFamily="18" charset="0"/>
                    </a:rPr>
                    <a:t>043</a:t>
                  </a:r>
                  <a:endParaRPr lang="fr-FR" sz="1100" i="1" dirty="0"/>
                </a:p>
              </p:txBody>
            </p:sp>
            <p:sp>
              <p:nvSpPr>
                <p:cNvPr id="154" name="ZoneTexte 153">
                  <a:extLst>
                    <a:ext uri="{FF2B5EF4-FFF2-40B4-BE49-F238E27FC236}">
                      <a16:creationId xmlns:a16="http://schemas.microsoft.com/office/drawing/2014/main" id="{C09F2A34-F177-4B6D-B2C8-B0CF8C1AA163}"/>
                    </a:ext>
                  </a:extLst>
                </p:cNvPr>
                <p:cNvSpPr txBox="1"/>
                <p:nvPr/>
              </p:nvSpPr>
              <p:spPr>
                <a:xfrm>
                  <a:off x="8925808" y="4316359"/>
                  <a:ext cx="210185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dirty="0">
                      <a:cs typeface="Times New Roman" panose="02020603050405020304" pitchFamily="18" charset="0"/>
                    </a:rPr>
                    <a:t>MD (95%CI):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90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(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049-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8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)</a:t>
                  </a:r>
                  <a:endParaRPr lang="fr-FR" sz="1100" dirty="0"/>
                </a:p>
              </p:txBody>
            </p:sp>
          </p:grpSp>
        </p:grpSp>
      </p:grpSp>
      <p:grpSp>
        <p:nvGrpSpPr>
          <p:cNvPr id="24" name="Groupe 23">
            <a:extLst>
              <a:ext uri="{FF2B5EF4-FFF2-40B4-BE49-F238E27FC236}">
                <a16:creationId xmlns:a16="http://schemas.microsoft.com/office/drawing/2014/main" id="{49D5CBB9-58B5-4775-9115-31D17601AB5D}"/>
              </a:ext>
            </a:extLst>
          </p:cNvPr>
          <p:cNvGrpSpPr/>
          <p:nvPr/>
        </p:nvGrpSpPr>
        <p:grpSpPr>
          <a:xfrm>
            <a:off x="1776188" y="3151597"/>
            <a:ext cx="8854727" cy="500133"/>
            <a:chOff x="1677573" y="3166475"/>
            <a:chExt cx="8854727" cy="500133"/>
          </a:xfrm>
        </p:grpSpPr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B2520940-CCB7-4E0D-96E4-AD15E216B607}"/>
                </a:ext>
              </a:extLst>
            </p:cNvPr>
            <p:cNvGrpSpPr/>
            <p:nvPr/>
          </p:nvGrpSpPr>
          <p:grpSpPr>
            <a:xfrm>
              <a:off x="1677573" y="3260800"/>
              <a:ext cx="6310944" cy="311483"/>
              <a:chOff x="1677573" y="3160399"/>
              <a:chExt cx="6310944" cy="311483"/>
            </a:xfrm>
          </p:grpSpPr>
          <p:grpSp>
            <p:nvGrpSpPr>
              <p:cNvPr id="5" name="Groupe 4">
                <a:extLst>
                  <a:ext uri="{FF2B5EF4-FFF2-40B4-BE49-F238E27FC236}">
                    <a16:creationId xmlns:a16="http://schemas.microsoft.com/office/drawing/2014/main" id="{858C8276-FDAC-444B-A072-C69F3A6DACDB}"/>
                  </a:ext>
                </a:extLst>
              </p:cNvPr>
              <p:cNvGrpSpPr/>
              <p:nvPr/>
            </p:nvGrpSpPr>
            <p:grpSpPr>
              <a:xfrm>
                <a:off x="2700221" y="3160399"/>
                <a:ext cx="5288296" cy="311483"/>
                <a:chOff x="2700221" y="3108203"/>
                <a:chExt cx="5288296" cy="311483"/>
              </a:xfrm>
            </p:grpSpPr>
            <p:sp>
              <p:nvSpPr>
                <p:cNvPr id="102" name="Forme libre : forme 101">
                  <a:extLst>
                    <a:ext uri="{FF2B5EF4-FFF2-40B4-BE49-F238E27FC236}">
                      <a16:creationId xmlns:a16="http://schemas.microsoft.com/office/drawing/2014/main" id="{708284F9-122C-4C8F-8DB7-16608FE15FFD}"/>
                    </a:ext>
                  </a:extLst>
                </p:cNvPr>
                <p:cNvSpPr/>
                <p:nvPr/>
              </p:nvSpPr>
              <p:spPr>
                <a:xfrm>
                  <a:off x="6960711" y="3164127"/>
                  <a:ext cx="1027806" cy="12692"/>
                </a:xfrm>
                <a:custGeom>
                  <a:avLst/>
                  <a:gdLst>
                    <a:gd name="connsiteX0" fmla="*/ 0 w 1041025"/>
                    <a:gd name="connsiteY0" fmla="*/ 0 h 12692"/>
                    <a:gd name="connsiteX1" fmla="*/ 1041026 w 1041025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041025" h="12692">
                      <a:moveTo>
                        <a:pt x="0" y="0"/>
                      </a:moveTo>
                      <a:lnTo>
                        <a:pt x="1041026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03" name="Forme libre : forme 102">
                  <a:extLst>
                    <a:ext uri="{FF2B5EF4-FFF2-40B4-BE49-F238E27FC236}">
                      <a16:creationId xmlns:a16="http://schemas.microsoft.com/office/drawing/2014/main" id="{7ED0F0B8-6289-4BAD-A46D-4E865DF88592}"/>
                    </a:ext>
                  </a:extLst>
                </p:cNvPr>
                <p:cNvSpPr/>
                <p:nvPr/>
              </p:nvSpPr>
              <p:spPr>
                <a:xfrm>
                  <a:off x="2700221" y="3363711"/>
                  <a:ext cx="4542936" cy="12692"/>
                </a:xfrm>
                <a:custGeom>
                  <a:avLst/>
                  <a:gdLst>
                    <a:gd name="connsiteX0" fmla="*/ 0 w 4601364"/>
                    <a:gd name="connsiteY0" fmla="*/ 0 h 12692"/>
                    <a:gd name="connsiteX1" fmla="*/ 4601365 w 4601364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4601364" h="12692">
                      <a:moveTo>
                        <a:pt x="0" y="0"/>
                      </a:moveTo>
                      <a:lnTo>
                        <a:pt x="4601365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04" name="Forme libre : forme 103">
                  <a:extLst>
                    <a:ext uri="{FF2B5EF4-FFF2-40B4-BE49-F238E27FC236}">
                      <a16:creationId xmlns:a16="http://schemas.microsoft.com/office/drawing/2014/main" id="{09E37E23-B224-44F9-AAD6-F32F0A087E8B}"/>
                    </a:ext>
                  </a:extLst>
                </p:cNvPr>
                <p:cNvSpPr/>
                <p:nvPr/>
              </p:nvSpPr>
              <p:spPr>
                <a:xfrm>
                  <a:off x="7519974" y="3108203"/>
                  <a:ext cx="110559" cy="111950"/>
                </a:xfrm>
                <a:custGeom>
                  <a:avLst/>
                  <a:gdLst>
                    <a:gd name="connsiteX0" fmla="*/ 0 w 111981"/>
                    <a:gd name="connsiteY0" fmla="*/ 111950 h 111950"/>
                    <a:gd name="connsiteX1" fmla="*/ 111982 w 111981"/>
                    <a:gd name="connsiteY1" fmla="*/ 111950 h 111950"/>
                    <a:gd name="connsiteX2" fmla="*/ 111982 w 111981"/>
                    <a:gd name="connsiteY2" fmla="*/ 0 h 111950"/>
                    <a:gd name="connsiteX3" fmla="*/ 0 w 111981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1" h="111950">
                      <a:moveTo>
                        <a:pt x="0" y="111950"/>
                      </a:moveTo>
                      <a:lnTo>
                        <a:pt x="111982" y="111950"/>
                      </a:lnTo>
                      <a:lnTo>
                        <a:pt x="111982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05" name="Forme libre : forme 104">
                  <a:extLst>
                    <a:ext uri="{FF2B5EF4-FFF2-40B4-BE49-F238E27FC236}">
                      <a16:creationId xmlns:a16="http://schemas.microsoft.com/office/drawing/2014/main" id="{4870B466-A788-417F-B1D6-15DCAFED82AE}"/>
                    </a:ext>
                  </a:extLst>
                </p:cNvPr>
                <p:cNvSpPr/>
                <p:nvPr/>
              </p:nvSpPr>
              <p:spPr>
                <a:xfrm>
                  <a:off x="4916416" y="3307736"/>
                  <a:ext cx="110546" cy="111950"/>
                </a:xfrm>
                <a:custGeom>
                  <a:avLst/>
                  <a:gdLst>
                    <a:gd name="connsiteX0" fmla="*/ 0 w 111968"/>
                    <a:gd name="connsiteY0" fmla="*/ 111950 h 111950"/>
                    <a:gd name="connsiteX1" fmla="*/ 111968 w 111968"/>
                    <a:gd name="connsiteY1" fmla="*/ 111950 h 111950"/>
                    <a:gd name="connsiteX2" fmla="*/ 111968 w 111968"/>
                    <a:gd name="connsiteY2" fmla="*/ 0 h 111950"/>
                    <a:gd name="connsiteX3" fmla="*/ 0 w 111968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68" h="111950">
                      <a:moveTo>
                        <a:pt x="0" y="111950"/>
                      </a:moveTo>
                      <a:lnTo>
                        <a:pt x="111968" y="111950"/>
                      </a:lnTo>
                      <a:lnTo>
                        <a:pt x="111968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10" name="Groupe 9">
                <a:extLst>
                  <a:ext uri="{FF2B5EF4-FFF2-40B4-BE49-F238E27FC236}">
                    <a16:creationId xmlns:a16="http://schemas.microsoft.com/office/drawing/2014/main" id="{B8720261-D3AB-46DC-B8C7-A554EB5B988E}"/>
                  </a:ext>
                </a:extLst>
              </p:cNvPr>
              <p:cNvGrpSpPr/>
              <p:nvPr/>
            </p:nvGrpSpPr>
            <p:grpSpPr>
              <a:xfrm>
                <a:off x="1677573" y="3177641"/>
                <a:ext cx="400117" cy="276999"/>
                <a:chOff x="1686536" y="3247078"/>
                <a:chExt cx="400117" cy="276999"/>
              </a:xfrm>
            </p:grpSpPr>
            <p:sp>
              <p:nvSpPr>
                <p:cNvPr id="106" name="Forme libre : forme 105">
                  <a:extLst>
                    <a:ext uri="{FF2B5EF4-FFF2-40B4-BE49-F238E27FC236}">
                      <a16:creationId xmlns:a16="http://schemas.microsoft.com/office/drawing/2014/main" id="{BBCAB203-050A-4BE6-A263-790E8576EC91}"/>
                    </a:ext>
                  </a:extLst>
                </p:cNvPr>
                <p:cNvSpPr/>
                <p:nvPr/>
              </p:nvSpPr>
              <p:spPr>
                <a:xfrm>
                  <a:off x="2032653" y="3379227"/>
                  <a:ext cx="54000" cy="12700"/>
                </a:xfrm>
                <a:custGeom>
                  <a:avLst/>
                  <a:gdLst>
                    <a:gd name="connsiteX0" fmla="*/ 0 w 34772"/>
                    <a:gd name="connsiteY0" fmla="*/ 0 h 12700"/>
                    <a:gd name="connsiteX1" fmla="*/ 34773 w 34772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4772" h="12700">
                      <a:moveTo>
                        <a:pt x="0" y="0"/>
                      </a:moveTo>
                      <a:lnTo>
                        <a:pt x="34773" y="0"/>
                      </a:lnTo>
                    </a:path>
                  </a:pathLst>
                </a:custGeom>
                <a:noFill/>
                <a:ln w="3175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07" name="ZoneTexte 106">
                  <a:extLst>
                    <a:ext uri="{FF2B5EF4-FFF2-40B4-BE49-F238E27FC236}">
                      <a16:creationId xmlns:a16="http://schemas.microsoft.com/office/drawing/2014/main" id="{C0B97AAB-BC56-4826-BF78-D0E8727DF407}"/>
                    </a:ext>
                  </a:extLst>
                </p:cNvPr>
                <p:cNvSpPr txBox="1"/>
                <p:nvPr/>
              </p:nvSpPr>
              <p:spPr>
                <a:xfrm>
                  <a:off x="1686536" y="3247078"/>
                  <a:ext cx="39119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200" dirty="0"/>
                    <a:t>IBV</a:t>
                  </a:r>
                </a:p>
              </p:txBody>
            </p:sp>
          </p:grpSp>
        </p:grpSp>
        <p:grpSp>
          <p:nvGrpSpPr>
            <p:cNvPr id="20" name="Groupe 19">
              <a:extLst>
                <a:ext uri="{FF2B5EF4-FFF2-40B4-BE49-F238E27FC236}">
                  <a16:creationId xmlns:a16="http://schemas.microsoft.com/office/drawing/2014/main" id="{C090FEAE-755E-4CB8-9D54-67BE017D2E0B}"/>
                </a:ext>
              </a:extLst>
            </p:cNvPr>
            <p:cNvGrpSpPr/>
            <p:nvPr/>
          </p:nvGrpSpPr>
          <p:grpSpPr>
            <a:xfrm>
              <a:off x="8438932" y="3166475"/>
              <a:ext cx="2093368" cy="500133"/>
              <a:chOff x="8438932" y="3166475"/>
              <a:chExt cx="2093368" cy="500133"/>
            </a:xfrm>
          </p:grpSpPr>
          <p:grpSp>
            <p:nvGrpSpPr>
              <p:cNvPr id="64" name="Groupe 63">
                <a:extLst>
                  <a:ext uri="{FF2B5EF4-FFF2-40B4-BE49-F238E27FC236}">
                    <a16:creationId xmlns:a16="http://schemas.microsoft.com/office/drawing/2014/main" id="{B39F0420-645B-4D26-96F7-0A8AB8C34358}"/>
                  </a:ext>
                </a:extLst>
              </p:cNvPr>
              <p:cNvGrpSpPr/>
              <p:nvPr/>
            </p:nvGrpSpPr>
            <p:grpSpPr>
              <a:xfrm>
                <a:off x="8574713" y="3200431"/>
                <a:ext cx="1957587" cy="432220"/>
                <a:chOff x="11430020" y="3173308"/>
                <a:chExt cx="1957587" cy="432220"/>
              </a:xfrm>
            </p:grpSpPr>
            <p:sp>
              <p:nvSpPr>
                <p:cNvPr id="158" name="ZoneTexte 157">
                  <a:extLst>
                    <a:ext uri="{FF2B5EF4-FFF2-40B4-BE49-F238E27FC236}">
                      <a16:creationId xmlns:a16="http://schemas.microsoft.com/office/drawing/2014/main" id="{1EF15A67-FD82-40DD-A4DC-A9B766B4AF1F}"/>
                    </a:ext>
                  </a:extLst>
                </p:cNvPr>
                <p:cNvSpPr txBox="1"/>
                <p:nvPr/>
              </p:nvSpPr>
              <p:spPr>
                <a:xfrm>
                  <a:off x="11437401" y="3173308"/>
                  <a:ext cx="50847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i="1" dirty="0"/>
                    <a:t>0.024</a:t>
                  </a:r>
                </a:p>
              </p:txBody>
            </p:sp>
            <p:sp>
              <p:nvSpPr>
                <p:cNvPr id="159" name="ZoneTexte 158">
                  <a:extLst>
                    <a:ext uri="{FF2B5EF4-FFF2-40B4-BE49-F238E27FC236}">
                      <a16:creationId xmlns:a16="http://schemas.microsoft.com/office/drawing/2014/main" id="{62C15DA9-C596-4D42-B56B-2F730FBB91B5}"/>
                    </a:ext>
                  </a:extLst>
                </p:cNvPr>
                <p:cNvSpPr txBox="1"/>
                <p:nvPr/>
              </p:nvSpPr>
              <p:spPr>
                <a:xfrm>
                  <a:off x="11430020" y="3343918"/>
                  <a:ext cx="19575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dirty="0">
                      <a:cs typeface="Times New Roman" panose="02020603050405020304" pitchFamily="18" charset="0"/>
                    </a:rPr>
                    <a:t>MD (95%CI):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1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(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42-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38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)</a:t>
                  </a:r>
                  <a:endParaRPr lang="fr-FR" sz="1100" dirty="0"/>
                </a:p>
              </p:txBody>
            </p:sp>
          </p:grpSp>
          <p:grpSp>
            <p:nvGrpSpPr>
              <p:cNvPr id="192" name="Groupe 191">
                <a:extLst>
                  <a:ext uri="{FF2B5EF4-FFF2-40B4-BE49-F238E27FC236}">
                    <a16:creationId xmlns:a16="http://schemas.microsoft.com/office/drawing/2014/main" id="{7EB53CFE-603F-4A7E-9B8D-C1F8D987E17F}"/>
                  </a:ext>
                </a:extLst>
              </p:cNvPr>
              <p:cNvGrpSpPr/>
              <p:nvPr/>
            </p:nvGrpSpPr>
            <p:grpSpPr>
              <a:xfrm>
                <a:off x="8438932" y="3166475"/>
                <a:ext cx="132592" cy="500133"/>
                <a:chOff x="8854922" y="4134571"/>
                <a:chExt cx="132592" cy="500133"/>
              </a:xfrm>
            </p:grpSpPr>
            <p:sp>
              <p:nvSpPr>
                <p:cNvPr id="193" name="Forme libre : forme 192">
                  <a:extLst>
                    <a:ext uri="{FF2B5EF4-FFF2-40B4-BE49-F238E27FC236}">
                      <a16:creationId xmlns:a16="http://schemas.microsoft.com/office/drawing/2014/main" id="{B6C99C5F-3D0B-48D2-8C1D-2A9CADBECF1A}"/>
                    </a:ext>
                  </a:extLst>
                </p:cNvPr>
                <p:cNvSpPr/>
                <p:nvPr/>
              </p:nvSpPr>
              <p:spPr>
                <a:xfrm>
                  <a:off x="8854922" y="4622012"/>
                  <a:ext cx="120996" cy="12692"/>
                </a:xfrm>
                <a:custGeom>
                  <a:avLst/>
                  <a:gdLst>
                    <a:gd name="connsiteX0" fmla="*/ 0 w 178362"/>
                    <a:gd name="connsiteY0" fmla="*/ 0 h 12692"/>
                    <a:gd name="connsiteX1" fmla="*/ 178362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0" y="0"/>
                      </a:moveTo>
                      <a:lnTo>
                        <a:pt x="178362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94" name="Forme libre : forme 193">
                  <a:extLst>
                    <a:ext uri="{FF2B5EF4-FFF2-40B4-BE49-F238E27FC236}">
                      <a16:creationId xmlns:a16="http://schemas.microsoft.com/office/drawing/2014/main" id="{ED30FACD-0979-4CB6-8086-4A86E5D9706D}"/>
                    </a:ext>
                  </a:extLst>
                </p:cNvPr>
                <p:cNvSpPr/>
                <p:nvPr/>
              </p:nvSpPr>
              <p:spPr>
                <a:xfrm>
                  <a:off x="8974820" y="4134571"/>
                  <a:ext cx="12694" cy="487440"/>
                </a:xfrm>
                <a:custGeom>
                  <a:avLst/>
                  <a:gdLst>
                    <a:gd name="connsiteX0" fmla="*/ 0 w 12694"/>
                    <a:gd name="connsiteY0" fmla="*/ 487440 h 487440"/>
                    <a:gd name="connsiteX1" fmla="*/ 0 w 12694"/>
                    <a:gd name="connsiteY1" fmla="*/ 0 h 4874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694" h="487440">
                      <a:moveTo>
                        <a:pt x="0" y="48744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95" name="Forme libre : forme 194">
                  <a:extLst>
                    <a:ext uri="{FF2B5EF4-FFF2-40B4-BE49-F238E27FC236}">
                      <a16:creationId xmlns:a16="http://schemas.microsoft.com/office/drawing/2014/main" id="{2A308824-994D-419E-9BE7-4464FED8D0C6}"/>
                    </a:ext>
                  </a:extLst>
                </p:cNvPr>
                <p:cNvSpPr/>
                <p:nvPr/>
              </p:nvSpPr>
              <p:spPr>
                <a:xfrm>
                  <a:off x="8854922" y="4134571"/>
                  <a:ext cx="120996" cy="12692"/>
                </a:xfrm>
                <a:custGeom>
                  <a:avLst/>
                  <a:gdLst>
                    <a:gd name="connsiteX0" fmla="*/ 178362 w 178362"/>
                    <a:gd name="connsiteY0" fmla="*/ 0 h 12692"/>
                    <a:gd name="connsiteX1" fmla="*/ 0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178362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</p:grp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393D0C52-EA97-4BF2-AC3D-B15235432952}"/>
              </a:ext>
            </a:extLst>
          </p:cNvPr>
          <p:cNvGrpSpPr/>
          <p:nvPr/>
        </p:nvGrpSpPr>
        <p:grpSpPr>
          <a:xfrm>
            <a:off x="1750334" y="2176625"/>
            <a:ext cx="8963105" cy="500133"/>
            <a:chOff x="1651719" y="2156990"/>
            <a:chExt cx="8963105" cy="500133"/>
          </a:xfrm>
        </p:grpSpPr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D7C01274-E4F9-4FFC-908E-D27BA8F46FB4}"/>
                </a:ext>
              </a:extLst>
            </p:cNvPr>
            <p:cNvGrpSpPr/>
            <p:nvPr/>
          </p:nvGrpSpPr>
          <p:grpSpPr>
            <a:xfrm>
              <a:off x="1651719" y="2240329"/>
              <a:ext cx="4759280" cy="333454"/>
              <a:chOff x="1651719" y="2164090"/>
              <a:chExt cx="4759280" cy="333454"/>
            </a:xfrm>
          </p:grpSpPr>
          <p:grpSp>
            <p:nvGrpSpPr>
              <p:cNvPr id="6" name="Groupe 5">
                <a:extLst>
                  <a:ext uri="{FF2B5EF4-FFF2-40B4-BE49-F238E27FC236}">
                    <a16:creationId xmlns:a16="http://schemas.microsoft.com/office/drawing/2014/main" id="{DA2731D3-9A33-4239-A9EA-2B8A0E3F22FA}"/>
                  </a:ext>
                </a:extLst>
              </p:cNvPr>
              <p:cNvGrpSpPr/>
              <p:nvPr/>
            </p:nvGrpSpPr>
            <p:grpSpPr>
              <a:xfrm>
                <a:off x="2367578" y="2164090"/>
                <a:ext cx="4043421" cy="333454"/>
                <a:chOff x="2367578" y="2101021"/>
                <a:chExt cx="4043421" cy="333454"/>
              </a:xfrm>
            </p:grpSpPr>
            <p:sp>
              <p:nvSpPr>
                <p:cNvPr id="89" name="Forme libre : forme 88">
                  <a:extLst>
                    <a:ext uri="{FF2B5EF4-FFF2-40B4-BE49-F238E27FC236}">
                      <a16:creationId xmlns:a16="http://schemas.microsoft.com/office/drawing/2014/main" id="{DD3538A4-9C88-49CC-A34E-052D05CA2344}"/>
                    </a:ext>
                  </a:extLst>
                </p:cNvPr>
                <p:cNvSpPr/>
                <p:nvPr/>
              </p:nvSpPr>
              <p:spPr>
                <a:xfrm>
                  <a:off x="4118525" y="2156996"/>
                  <a:ext cx="2292474" cy="12692"/>
                </a:xfrm>
                <a:custGeom>
                  <a:avLst/>
                  <a:gdLst>
                    <a:gd name="connsiteX0" fmla="*/ 0 w 2321958"/>
                    <a:gd name="connsiteY0" fmla="*/ 0 h 12692"/>
                    <a:gd name="connsiteX1" fmla="*/ 2321959 w 2321958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321958" h="12692">
                      <a:moveTo>
                        <a:pt x="0" y="0"/>
                      </a:moveTo>
                      <a:lnTo>
                        <a:pt x="2321959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90" name="Forme libre : forme 89">
                  <a:extLst>
                    <a:ext uri="{FF2B5EF4-FFF2-40B4-BE49-F238E27FC236}">
                      <a16:creationId xmlns:a16="http://schemas.microsoft.com/office/drawing/2014/main" id="{978A7073-9371-4E6E-8991-A36DB35EF648}"/>
                    </a:ext>
                  </a:extLst>
                </p:cNvPr>
                <p:cNvSpPr/>
                <p:nvPr/>
              </p:nvSpPr>
              <p:spPr>
                <a:xfrm>
                  <a:off x="2367578" y="2378500"/>
                  <a:ext cx="2567148" cy="12692"/>
                </a:xfrm>
                <a:custGeom>
                  <a:avLst/>
                  <a:gdLst>
                    <a:gd name="connsiteX0" fmla="*/ 0 w 2600165"/>
                    <a:gd name="connsiteY0" fmla="*/ 0 h 12692"/>
                    <a:gd name="connsiteX1" fmla="*/ 2600166 w 2600165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2600165" h="12692">
                      <a:moveTo>
                        <a:pt x="0" y="0"/>
                      </a:moveTo>
                      <a:lnTo>
                        <a:pt x="2600166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91" name="Forme libre : forme 90">
                  <a:extLst>
                    <a:ext uri="{FF2B5EF4-FFF2-40B4-BE49-F238E27FC236}">
                      <a16:creationId xmlns:a16="http://schemas.microsoft.com/office/drawing/2014/main" id="{EB85E499-0300-4901-B0E5-501A35111468}"/>
                    </a:ext>
                  </a:extLst>
                </p:cNvPr>
                <p:cNvSpPr/>
                <p:nvPr/>
              </p:nvSpPr>
              <p:spPr>
                <a:xfrm>
                  <a:off x="5209489" y="2101021"/>
                  <a:ext cx="110546" cy="111950"/>
                </a:xfrm>
                <a:custGeom>
                  <a:avLst/>
                  <a:gdLst>
                    <a:gd name="connsiteX0" fmla="*/ 0 w 111968"/>
                    <a:gd name="connsiteY0" fmla="*/ 111950 h 111950"/>
                    <a:gd name="connsiteX1" fmla="*/ 111968 w 111968"/>
                    <a:gd name="connsiteY1" fmla="*/ 111950 h 111950"/>
                    <a:gd name="connsiteX2" fmla="*/ 111968 w 111968"/>
                    <a:gd name="connsiteY2" fmla="*/ 0 h 111950"/>
                    <a:gd name="connsiteX3" fmla="*/ 0 w 111968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68" h="111950">
                      <a:moveTo>
                        <a:pt x="0" y="111950"/>
                      </a:moveTo>
                      <a:lnTo>
                        <a:pt x="111968" y="111950"/>
                      </a:lnTo>
                      <a:lnTo>
                        <a:pt x="111968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92" name="Forme libre : forme 91">
                  <a:extLst>
                    <a:ext uri="{FF2B5EF4-FFF2-40B4-BE49-F238E27FC236}">
                      <a16:creationId xmlns:a16="http://schemas.microsoft.com/office/drawing/2014/main" id="{7AC24B7E-8BC7-44D2-AAA4-160BB7ED5F8A}"/>
                    </a:ext>
                  </a:extLst>
                </p:cNvPr>
                <p:cNvSpPr/>
                <p:nvPr/>
              </p:nvSpPr>
              <p:spPr>
                <a:xfrm>
                  <a:off x="3595873" y="2322525"/>
                  <a:ext cx="110559" cy="111950"/>
                </a:xfrm>
                <a:custGeom>
                  <a:avLst/>
                  <a:gdLst>
                    <a:gd name="connsiteX0" fmla="*/ 0 w 111981"/>
                    <a:gd name="connsiteY0" fmla="*/ 111950 h 111950"/>
                    <a:gd name="connsiteX1" fmla="*/ 111981 w 111981"/>
                    <a:gd name="connsiteY1" fmla="*/ 111950 h 111950"/>
                    <a:gd name="connsiteX2" fmla="*/ 111981 w 111981"/>
                    <a:gd name="connsiteY2" fmla="*/ 0 h 111950"/>
                    <a:gd name="connsiteX3" fmla="*/ 0 w 111981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1" h="111950">
                      <a:moveTo>
                        <a:pt x="0" y="111950"/>
                      </a:moveTo>
                      <a:lnTo>
                        <a:pt x="111981" y="111950"/>
                      </a:lnTo>
                      <a:lnTo>
                        <a:pt x="11198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9" name="Groupe 8">
                <a:extLst>
                  <a:ext uri="{FF2B5EF4-FFF2-40B4-BE49-F238E27FC236}">
                    <a16:creationId xmlns:a16="http://schemas.microsoft.com/office/drawing/2014/main" id="{B9317E28-6A60-4759-B527-C446163CCF6E}"/>
                  </a:ext>
                </a:extLst>
              </p:cNvPr>
              <p:cNvGrpSpPr/>
              <p:nvPr/>
            </p:nvGrpSpPr>
            <p:grpSpPr>
              <a:xfrm>
                <a:off x="1651719" y="2192318"/>
                <a:ext cx="425971" cy="276999"/>
                <a:chOff x="1660682" y="2283615"/>
                <a:chExt cx="425971" cy="276999"/>
              </a:xfrm>
            </p:grpSpPr>
            <p:sp>
              <p:nvSpPr>
                <p:cNvPr id="94" name="ZoneTexte 93">
                  <a:extLst>
                    <a:ext uri="{FF2B5EF4-FFF2-40B4-BE49-F238E27FC236}">
                      <a16:creationId xmlns:a16="http://schemas.microsoft.com/office/drawing/2014/main" id="{177CF842-7087-4D24-8D1F-88D4660EFCF8}"/>
                    </a:ext>
                  </a:extLst>
                </p:cNvPr>
                <p:cNvSpPr txBox="1"/>
                <p:nvPr/>
              </p:nvSpPr>
              <p:spPr>
                <a:xfrm>
                  <a:off x="1660682" y="2283615"/>
                  <a:ext cx="4220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200" dirty="0"/>
                    <a:t>RSV</a:t>
                  </a:r>
                </a:p>
              </p:txBody>
            </p:sp>
            <p:sp>
              <p:nvSpPr>
                <p:cNvPr id="93" name="Forme libre : forme 92">
                  <a:extLst>
                    <a:ext uri="{FF2B5EF4-FFF2-40B4-BE49-F238E27FC236}">
                      <a16:creationId xmlns:a16="http://schemas.microsoft.com/office/drawing/2014/main" id="{8F5B7B0E-1D30-4F0F-ABA4-C9D0522094D9}"/>
                    </a:ext>
                  </a:extLst>
                </p:cNvPr>
                <p:cNvSpPr/>
                <p:nvPr/>
              </p:nvSpPr>
              <p:spPr>
                <a:xfrm>
                  <a:off x="2032653" y="2415764"/>
                  <a:ext cx="54000" cy="12700"/>
                </a:xfrm>
                <a:custGeom>
                  <a:avLst/>
                  <a:gdLst>
                    <a:gd name="connsiteX0" fmla="*/ 0 w 34772"/>
                    <a:gd name="connsiteY0" fmla="*/ 0 h 12700"/>
                    <a:gd name="connsiteX1" fmla="*/ 34773 w 34772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4772" h="12700">
                      <a:moveTo>
                        <a:pt x="0" y="0"/>
                      </a:moveTo>
                      <a:lnTo>
                        <a:pt x="34773" y="0"/>
                      </a:lnTo>
                    </a:path>
                  </a:pathLst>
                </a:custGeom>
                <a:noFill/>
                <a:ln w="3175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</p:grpSp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241E432A-6007-459D-A5FE-A18966BD0BFE}"/>
                </a:ext>
              </a:extLst>
            </p:cNvPr>
            <p:cNvGrpSpPr/>
            <p:nvPr/>
          </p:nvGrpSpPr>
          <p:grpSpPr>
            <a:xfrm>
              <a:off x="8436911" y="2156990"/>
              <a:ext cx="2177913" cy="500133"/>
              <a:chOff x="8436911" y="2156990"/>
              <a:chExt cx="2177913" cy="500133"/>
            </a:xfrm>
          </p:grpSpPr>
          <p:grpSp>
            <p:nvGrpSpPr>
              <p:cNvPr id="65" name="Groupe 64">
                <a:extLst>
                  <a:ext uri="{FF2B5EF4-FFF2-40B4-BE49-F238E27FC236}">
                    <a16:creationId xmlns:a16="http://schemas.microsoft.com/office/drawing/2014/main" id="{2C402278-9687-41F5-A990-3E78398BF13C}"/>
                  </a:ext>
                </a:extLst>
              </p:cNvPr>
              <p:cNvGrpSpPr/>
              <p:nvPr/>
            </p:nvGrpSpPr>
            <p:grpSpPr>
              <a:xfrm>
                <a:off x="8574713" y="2180494"/>
                <a:ext cx="2040111" cy="453125"/>
                <a:chOff x="11435119" y="2205654"/>
                <a:chExt cx="2040111" cy="453125"/>
              </a:xfrm>
            </p:grpSpPr>
            <p:sp>
              <p:nvSpPr>
                <p:cNvPr id="163" name="ZoneTexte 162">
                  <a:extLst>
                    <a:ext uri="{FF2B5EF4-FFF2-40B4-BE49-F238E27FC236}">
                      <a16:creationId xmlns:a16="http://schemas.microsoft.com/office/drawing/2014/main" id="{FDC586B1-15AA-45E2-B158-DE001EC17821}"/>
                    </a:ext>
                  </a:extLst>
                </p:cNvPr>
                <p:cNvSpPr txBox="1"/>
                <p:nvPr/>
              </p:nvSpPr>
              <p:spPr>
                <a:xfrm>
                  <a:off x="11435119" y="2205654"/>
                  <a:ext cx="50847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i="1" dirty="0"/>
                    <a:t>0.043</a:t>
                  </a:r>
                </a:p>
              </p:txBody>
            </p:sp>
            <p:sp>
              <p:nvSpPr>
                <p:cNvPr id="164" name="ZoneTexte 163">
                  <a:extLst>
                    <a:ext uri="{FF2B5EF4-FFF2-40B4-BE49-F238E27FC236}">
                      <a16:creationId xmlns:a16="http://schemas.microsoft.com/office/drawing/2014/main" id="{68AA0751-2F7F-4C7A-A3A2-2048AAE34227}"/>
                    </a:ext>
                  </a:extLst>
                </p:cNvPr>
                <p:cNvSpPr txBox="1"/>
                <p:nvPr/>
              </p:nvSpPr>
              <p:spPr>
                <a:xfrm>
                  <a:off x="11445507" y="2397169"/>
                  <a:ext cx="202972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dirty="0">
                      <a:cs typeface="Times New Roman" panose="02020603050405020304" pitchFamily="18" charset="0"/>
                    </a:rPr>
                    <a:t>MD (95%CI):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3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(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039-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)</a:t>
                  </a:r>
                  <a:endParaRPr lang="fr-FR" sz="1100" dirty="0"/>
                </a:p>
              </p:txBody>
            </p:sp>
          </p:grpSp>
          <p:grpSp>
            <p:nvGrpSpPr>
              <p:cNvPr id="196" name="Groupe 195">
                <a:extLst>
                  <a:ext uri="{FF2B5EF4-FFF2-40B4-BE49-F238E27FC236}">
                    <a16:creationId xmlns:a16="http://schemas.microsoft.com/office/drawing/2014/main" id="{D7FADCCB-FA21-430A-AE3D-8142DC58BC7F}"/>
                  </a:ext>
                </a:extLst>
              </p:cNvPr>
              <p:cNvGrpSpPr/>
              <p:nvPr/>
            </p:nvGrpSpPr>
            <p:grpSpPr>
              <a:xfrm>
                <a:off x="8436911" y="2156990"/>
                <a:ext cx="132592" cy="500133"/>
                <a:chOff x="8854922" y="4134571"/>
                <a:chExt cx="132592" cy="500133"/>
              </a:xfrm>
            </p:grpSpPr>
            <p:sp>
              <p:nvSpPr>
                <p:cNvPr id="197" name="Forme libre : forme 196">
                  <a:extLst>
                    <a:ext uri="{FF2B5EF4-FFF2-40B4-BE49-F238E27FC236}">
                      <a16:creationId xmlns:a16="http://schemas.microsoft.com/office/drawing/2014/main" id="{80A63F30-B119-43B9-A56D-1B048031D2CA}"/>
                    </a:ext>
                  </a:extLst>
                </p:cNvPr>
                <p:cNvSpPr/>
                <p:nvPr/>
              </p:nvSpPr>
              <p:spPr>
                <a:xfrm>
                  <a:off x="8854922" y="4622012"/>
                  <a:ext cx="120996" cy="12692"/>
                </a:xfrm>
                <a:custGeom>
                  <a:avLst/>
                  <a:gdLst>
                    <a:gd name="connsiteX0" fmla="*/ 0 w 178362"/>
                    <a:gd name="connsiteY0" fmla="*/ 0 h 12692"/>
                    <a:gd name="connsiteX1" fmla="*/ 178362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0" y="0"/>
                      </a:moveTo>
                      <a:lnTo>
                        <a:pt x="178362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98" name="Forme libre : forme 197">
                  <a:extLst>
                    <a:ext uri="{FF2B5EF4-FFF2-40B4-BE49-F238E27FC236}">
                      <a16:creationId xmlns:a16="http://schemas.microsoft.com/office/drawing/2014/main" id="{2CCBFCBF-4CF0-4A19-8943-9AA8C1733097}"/>
                    </a:ext>
                  </a:extLst>
                </p:cNvPr>
                <p:cNvSpPr/>
                <p:nvPr/>
              </p:nvSpPr>
              <p:spPr>
                <a:xfrm>
                  <a:off x="8974820" y="4134571"/>
                  <a:ext cx="12694" cy="487440"/>
                </a:xfrm>
                <a:custGeom>
                  <a:avLst/>
                  <a:gdLst>
                    <a:gd name="connsiteX0" fmla="*/ 0 w 12694"/>
                    <a:gd name="connsiteY0" fmla="*/ 487440 h 487440"/>
                    <a:gd name="connsiteX1" fmla="*/ 0 w 12694"/>
                    <a:gd name="connsiteY1" fmla="*/ 0 h 4874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694" h="487440">
                      <a:moveTo>
                        <a:pt x="0" y="48744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199" name="Forme libre : forme 198">
                  <a:extLst>
                    <a:ext uri="{FF2B5EF4-FFF2-40B4-BE49-F238E27FC236}">
                      <a16:creationId xmlns:a16="http://schemas.microsoft.com/office/drawing/2014/main" id="{5BC1D63D-58B3-40A0-A474-4E4A5670C721}"/>
                    </a:ext>
                  </a:extLst>
                </p:cNvPr>
                <p:cNvSpPr/>
                <p:nvPr/>
              </p:nvSpPr>
              <p:spPr>
                <a:xfrm>
                  <a:off x="8854922" y="4134571"/>
                  <a:ext cx="120996" cy="12692"/>
                </a:xfrm>
                <a:custGeom>
                  <a:avLst/>
                  <a:gdLst>
                    <a:gd name="connsiteX0" fmla="*/ 178362 w 178362"/>
                    <a:gd name="connsiteY0" fmla="*/ 0 h 12692"/>
                    <a:gd name="connsiteX1" fmla="*/ 0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178362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</p:grp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7D5F1D2B-7C04-4B8E-BB2F-6A371D28F0F4}"/>
              </a:ext>
            </a:extLst>
          </p:cNvPr>
          <p:cNvGrpSpPr/>
          <p:nvPr/>
        </p:nvGrpSpPr>
        <p:grpSpPr>
          <a:xfrm>
            <a:off x="1255134" y="1201652"/>
            <a:ext cx="9375781" cy="500133"/>
            <a:chOff x="1156519" y="1201652"/>
            <a:chExt cx="9375781" cy="500133"/>
          </a:xfrm>
        </p:grpSpPr>
        <p:grpSp>
          <p:nvGrpSpPr>
            <p:cNvPr id="13" name="Groupe 12">
              <a:extLst>
                <a:ext uri="{FF2B5EF4-FFF2-40B4-BE49-F238E27FC236}">
                  <a16:creationId xmlns:a16="http://schemas.microsoft.com/office/drawing/2014/main" id="{E2578899-C027-47D1-9B38-5A79AF6EFF31}"/>
                </a:ext>
              </a:extLst>
            </p:cNvPr>
            <p:cNvGrpSpPr/>
            <p:nvPr/>
          </p:nvGrpSpPr>
          <p:grpSpPr>
            <a:xfrm>
              <a:off x="1156519" y="1313219"/>
              <a:ext cx="5505557" cy="276999"/>
              <a:chOff x="1156519" y="1223896"/>
              <a:chExt cx="5505557" cy="276999"/>
            </a:xfrm>
          </p:grpSpPr>
          <p:grpSp>
            <p:nvGrpSpPr>
              <p:cNvPr id="7" name="Groupe 6">
                <a:extLst>
                  <a:ext uri="{FF2B5EF4-FFF2-40B4-BE49-F238E27FC236}">
                    <a16:creationId xmlns:a16="http://schemas.microsoft.com/office/drawing/2014/main" id="{F56D615F-AF10-40AB-AE5C-43FCAFCAB295}"/>
                  </a:ext>
                </a:extLst>
              </p:cNvPr>
              <p:cNvGrpSpPr/>
              <p:nvPr/>
            </p:nvGrpSpPr>
            <p:grpSpPr>
              <a:xfrm>
                <a:off x="3437501" y="1231392"/>
                <a:ext cx="3224575" cy="262007"/>
                <a:chOff x="3437501" y="1156562"/>
                <a:chExt cx="3224575" cy="262007"/>
              </a:xfrm>
            </p:grpSpPr>
            <p:sp>
              <p:nvSpPr>
                <p:cNvPr id="82" name="Forme libre : forme 81">
                  <a:extLst>
                    <a:ext uri="{FF2B5EF4-FFF2-40B4-BE49-F238E27FC236}">
                      <a16:creationId xmlns:a16="http://schemas.microsoft.com/office/drawing/2014/main" id="{2A781322-2BB3-4643-9460-EA8B01E37B85}"/>
                    </a:ext>
                  </a:extLst>
                </p:cNvPr>
                <p:cNvSpPr/>
                <p:nvPr/>
              </p:nvSpPr>
              <p:spPr>
                <a:xfrm>
                  <a:off x="5282638" y="1212537"/>
                  <a:ext cx="1379438" cy="12692"/>
                </a:xfrm>
                <a:custGeom>
                  <a:avLst/>
                  <a:gdLst>
                    <a:gd name="connsiteX0" fmla="*/ 0 w 1397179"/>
                    <a:gd name="connsiteY0" fmla="*/ 0 h 12692"/>
                    <a:gd name="connsiteX1" fmla="*/ 1397179 w 1397179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397179" h="12692">
                      <a:moveTo>
                        <a:pt x="0" y="0"/>
                      </a:moveTo>
                      <a:lnTo>
                        <a:pt x="1397179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83" name="Forme libre : forme 82">
                  <a:extLst>
                    <a:ext uri="{FF2B5EF4-FFF2-40B4-BE49-F238E27FC236}">
                      <a16:creationId xmlns:a16="http://schemas.microsoft.com/office/drawing/2014/main" id="{71CD0FB5-1256-4EC3-91C2-E5A1134C5806}"/>
                    </a:ext>
                  </a:extLst>
                </p:cNvPr>
                <p:cNvSpPr/>
                <p:nvPr/>
              </p:nvSpPr>
              <p:spPr>
                <a:xfrm>
                  <a:off x="3437501" y="1362594"/>
                  <a:ext cx="1823741" cy="12692"/>
                </a:xfrm>
                <a:custGeom>
                  <a:avLst/>
                  <a:gdLst>
                    <a:gd name="connsiteX0" fmla="*/ 0 w 1847197"/>
                    <a:gd name="connsiteY0" fmla="*/ 0 h 12692"/>
                    <a:gd name="connsiteX1" fmla="*/ 1847198 w 1847197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847197" h="12692">
                      <a:moveTo>
                        <a:pt x="0" y="0"/>
                      </a:moveTo>
                      <a:lnTo>
                        <a:pt x="1847198" y="0"/>
                      </a:lnTo>
                    </a:path>
                  </a:pathLst>
                </a:custGeom>
                <a:noFill/>
                <a:ln w="3175" cap="flat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84" name="Forme libre : forme 83">
                  <a:extLst>
                    <a:ext uri="{FF2B5EF4-FFF2-40B4-BE49-F238E27FC236}">
                      <a16:creationId xmlns:a16="http://schemas.microsoft.com/office/drawing/2014/main" id="{2479FFD6-5759-47A3-8F7D-2592BF0B5B16}"/>
                    </a:ext>
                  </a:extLst>
                </p:cNvPr>
                <p:cNvSpPr/>
                <p:nvPr/>
              </p:nvSpPr>
              <p:spPr>
                <a:xfrm>
                  <a:off x="5917052" y="1156562"/>
                  <a:ext cx="110558" cy="111950"/>
                </a:xfrm>
                <a:custGeom>
                  <a:avLst/>
                  <a:gdLst>
                    <a:gd name="connsiteX0" fmla="*/ 0 w 111980"/>
                    <a:gd name="connsiteY0" fmla="*/ 111950 h 111950"/>
                    <a:gd name="connsiteX1" fmla="*/ 111981 w 111980"/>
                    <a:gd name="connsiteY1" fmla="*/ 111950 h 111950"/>
                    <a:gd name="connsiteX2" fmla="*/ 111981 w 111980"/>
                    <a:gd name="connsiteY2" fmla="*/ 0 h 111950"/>
                    <a:gd name="connsiteX3" fmla="*/ 0 w 111980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80" h="111950">
                      <a:moveTo>
                        <a:pt x="0" y="111950"/>
                      </a:moveTo>
                      <a:lnTo>
                        <a:pt x="111981" y="111950"/>
                      </a:lnTo>
                      <a:lnTo>
                        <a:pt x="11198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bg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85" name="Forme libre : forme 84">
                  <a:extLst>
                    <a:ext uri="{FF2B5EF4-FFF2-40B4-BE49-F238E27FC236}">
                      <a16:creationId xmlns:a16="http://schemas.microsoft.com/office/drawing/2014/main" id="{0F0E073D-CECE-49A5-9DC8-89E970F3013E}"/>
                    </a:ext>
                  </a:extLst>
                </p:cNvPr>
                <p:cNvSpPr/>
                <p:nvPr/>
              </p:nvSpPr>
              <p:spPr>
                <a:xfrm>
                  <a:off x="4294099" y="1306619"/>
                  <a:ext cx="110546" cy="111950"/>
                </a:xfrm>
                <a:custGeom>
                  <a:avLst/>
                  <a:gdLst>
                    <a:gd name="connsiteX0" fmla="*/ 0 w 111968"/>
                    <a:gd name="connsiteY0" fmla="*/ 111950 h 111950"/>
                    <a:gd name="connsiteX1" fmla="*/ 111968 w 111968"/>
                    <a:gd name="connsiteY1" fmla="*/ 111950 h 111950"/>
                    <a:gd name="connsiteX2" fmla="*/ 111968 w 111968"/>
                    <a:gd name="connsiteY2" fmla="*/ 0 h 111950"/>
                    <a:gd name="connsiteX3" fmla="*/ 0 w 111968"/>
                    <a:gd name="connsiteY3" fmla="*/ 0 h 111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111968" h="111950">
                      <a:moveTo>
                        <a:pt x="0" y="111950"/>
                      </a:moveTo>
                      <a:lnTo>
                        <a:pt x="111968" y="111950"/>
                      </a:lnTo>
                      <a:lnTo>
                        <a:pt x="111968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3175" cap="rnd">
                  <a:solidFill>
                    <a:schemeClr val="tx1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  <p:grpSp>
            <p:nvGrpSpPr>
              <p:cNvPr id="8" name="Groupe 7">
                <a:extLst>
                  <a:ext uri="{FF2B5EF4-FFF2-40B4-BE49-F238E27FC236}">
                    <a16:creationId xmlns:a16="http://schemas.microsoft.com/office/drawing/2014/main" id="{7DCAB3E1-C7ED-47BE-9A83-72B7BF3D565F}"/>
                  </a:ext>
                </a:extLst>
              </p:cNvPr>
              <p:cNvGrpSpPr/>
              <p:nvPr/>
            </p:nvGrpSpPr>
            <p:grpSpPr>
              <a:xfrm>
                <a:off x="1156519" y="1223896"/>
                <a:ext cx="921171" cy="276999"/>
                <a:chOff x="1165482" y="1291229"/>
                <a:chExt cx="921171" cy="276999"/>
              </a:xfrm>
            </p:grpSpPr>
            <p:sp>
              <p:nvSpPr>
                <p:cNvPr id="87" name="ZoneTexte 86">
                  <a:extLst>
                    <a:ext uri="{FF2B5EF4-FFF2-40B4-BE49-F238E27FC236}">
                      <a16:creationId xmlns:a16="http://schemas.microsoft.com/office/drawing/2014/main" id="{1ED4BA38-EEB7-4275-B62B-2282FD4B4567}"/>
                    </a:ext>
                  </a:extLst>
                </p:cNvPr>
                <p:cNvSpPr txBox="1"/>
                <p:nvPr/>
              </p:nvSpPr>
              <p:spPr>
                <a:xfrm>
                  <a:off x="1165482" y="1291229"/>
                  <a:ext cx="9172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1200" dirty="0"/>
                    <a:t>SARS-CoV-2</a:t>
                  </a:r>
                </a:p>
              </p:txBody>
            </p:sp>
            <p:sp>
              <p:nvSpPr>
                <p:cNvPr id="86" name="Forme libre : forme 85">
                  <a:extLst>
                    <a:ext uri="{FF2B5EF4-FFF2-40B4-BE49-F238E27FC236}">
                      <a16:creationId xmlns:a16="http://schemas.microsoft.com/office/drawing/2014/main" id="{D2278439-5DC5-41DB-9E1A-D498E9DCA808}"/>
                    </a:ext>
                  </a:extLst>
                </p:cNvPr>
                <p:cNvSpPr/>
                <p:nvPr/>
              </p:nvSpPr>
              <p:spPr>
                <a:xfrm>
                  <a:off x="2032653" y="1423378"/>
                  <a:ext cx="54000" cy="12700"/>
                </a:xfrm>
                <a:custGeom>
                  <a:avLst/>
                  <a:gdLst>
                    <a:gd name="connsiteX0" fmla="*/ 0 w 34772"/>
                    <a:gd name="connsiteY0" fmla="*/ 0 h 12700"/>
                    <a:gd name="connsiteX1" fmla="*/ 34773 w 34772"/>
                    <a:gd name="connsiteY1" fmla="*/ 0 h 127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34772" h="12700">
                      <a:moveTo>
                        <a:pt x="0" y="0"/>
                      </a:moveTo>
                      <a:lnTo>
                        <a:pt x="34773" y="0"/>
                      </a:lnTo>
                    </a:path>
                  </a:pathLst>
                </a:custGeom>
                <a:noFill/>
                <a:ln w="3175" cap="flat">
                  <a:solidFill>
                    <a:srgbClr val="333333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</p:grpSp>
        <p:grpSp>
          <p:nvGrpSpPr>
            <p:cNvPr id="18" name="Groupe 17">
              <a:extLst>
                <a:ext uri="{FF2B5EF4-FFF2-40B4-BE49-F238E27FC236}">
                  <a16:creationId xmlns:a16="http://schemas.microsoft.com/office/drawing/2014/main" id="{46CE571A-5A0A-4BF6-A50E-3B2F3C6BC497}"/>
                </a:ext>
              </a:extLst>
            </p:cNvPr>
            <p:cNvGrpSpPr/>
            <p:nvPr/>
          </p:nvGrpSpPr>
          <p:grpSpPr>
            <a:xfrm>
              <a:off x="8434432" y="1201652"/>
              <a:ext cx="2097868" cy="500133"/>
              <a:chOff x="8434432" y="1201652"/>
              <a:chExt cx="2097868" cy="500133"/>
            </a:xfrm>
          </p:grpSpPr>
          <p:grpSp>
            <p:nvGrpSpPr>
              <p:cNvPr id="66" name="Groupe 65">
                <a:extLst>
                  <a:ext uri="{FF2B5EF4-FFF2-40B4-BE49-F238E27FC236}">
                    <a16:creationId xmlns:a16="http://schemas.microsoft.com/office/drawing/2014/main" id="{EBEB74A2-224C-46E4-A791-5DBDF5772F81}"/>
                  </a:ext>
                </a:extLst>
              </p:cNvPr>
              <p:cNvGrpSpPr/>
              <p:nvPr/>
            </p:nvGrpSpPr>
            <p:grpSpPr>
              <a:xfrm>
                <a:off x="8574713" y="1234631"/>
                <a:ext cx="1957587" cy="434174"/>
                <a:chOff x="11437401" y="1316222"/>
                <a:chExt cx="1957587" cy="434174"/>
              </a:xfrm>
            </p:grpSpPr>
            <p:sp>
              <p:nvSpPr>
                <p:cNvPr id="168" name="ZoneTexte 167">
                  <a:extLst>
                    <a:ext uri="{FF2B5EF4-FFF2-40B4-BE49-F238E27FC236}">
                      <a16:creationId xmlns:a16="http://schemas.microsoft.com/office/drawing/2014/main" id="{85FE9545-32CC-4E21-AE0F-6BA1118F2006}"/>
                    </a:ext>
                  </a:extLst>
                </p:cNvPr>
                <p:cNvSpPr txBox="1"/>
                <p:nvPr/>
              </p:nvSpPr>
              <p:spPr>
                <a:xfrm>
                  <a:off x="11437401" y="1316222"/>
                  <a:ext cx="5806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i="1" dirty="0">
                      <a:cs typeface="Times New Roman" panose="02020603050405020304" pitchFamily="18" charset="0"/>
                    </a:rPr>
                    <a:t>0</a:t>
                  </a:r>
                  <a:r>
                    <a:rPr lang="en-GB" sz="1100" i="1" dirty="0">
                      <a:cs typeface="Times New Roman" panose="02020603050405020304" pitchFamily="18" charset="0"/>
                    </a:rPr>
                    <a:t>.</a:t>
                  </a:r>
                  <a:r>
                    <a:rPr lang="en-GB" sz="1100" i="1" dirty="0">
                      <a:ea typeface="Times New Roman" panose="02020603050405020304" pitchFamily="18" charset="0"/>
                    </a:rPr>
                    <a:t>0010</a:t>
                  </a:r>
                  <a:endParaRPr lang="fr-FR" sz="1100" i="1" dirty="0"/>
                </a:p>
              </p:txBody>
            </p:sp>
            <p:sp>
              <p:nvSpPr>
                <p:cNvPr id="169" name="ZoneTexte 168">
                  <a:extLst>
                    <a:ext uri="{FF2B5EF4-FFF2-40B4-BE49-F238E27FC236}">
                      <a16:creationId xmlns:a16="http://schemas.microsoft.com/office/drawing/2014/main" id="{3C8FED33-5EC3-457C-84E4-D6BA9B32CCC9}"/>
                    </a:ext>
                  </a:extLst>
                </p:cNvPr>
                <p:cNvSpPr txBox="1"/>
                <p:nvPr/>
              </p:nvSpPr>
              <p:spPr>
                <a:xfrm>
                  <a:off x="11437401" y="1488786"/>
                  <a:ext cx="195758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dirty="0">
                      <a:cs typeface="Times New Roman" panose="02020603050405020304" pitchFamily="18" charset="0"/>
                    </a:rPr>
                    <a:t>MD (95%CI):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13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(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058-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 0</a:t>
                  </a:r>
                  <a:r>
                    <a:rPr lang="en-GB" sz="1100" dirty="0">
                      <a:cs typeface="Times New Roman" panose="02020603050405020304" pitchFamily="18" charset="0"/>
                    </a:rPr>
                    <a:t>.</a:t>
                  </a:r>
                  <a:r>
                    <a:rPr lang="fr-FR" sz="1100" dirty="0"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r>
                    <a:rPr lang="fr-FR" sz="1100" dirty="0">
                      <a:cs typeface="Times New Roman" panose="02020603050405020304" pitchFamily="18" charset="0"/>
                    </a:rPr>
                    <a:t>)</a:t>
                  </a:r>
                  <a:endParaRPr lang="fr-FR" sz="1100" dirty="0"/>
                </a:p>
              </p:txBody>
            </p:sp>
          </p:grpSp>
          <p:grpSp>
            <p:nvGrpSpPr>
              <p:cNvPr id="200" name="Groupe 199">
                <a:extLst>
                  <a:ext uri="{FF2B5EF4-FFF2-40B4-BE49-F238E27FC236}">
                    <a16:creationId xmlns:a16="http://schemas.microsoft.com/office/drawing/2014/main" id="{F8CB1555-D7FF-4722-A46B-992524DA4BA1}"/>
                  </a:ext>
                </a:extLst>
              </p:cNvPr>
              <p:cNvGrpSpPr/>
              <p:nvPr/>
            </p:nvGrpSpPr>
            <p:grpSpPr>
              <a:xfrm>
                <a:off x="8434432" y="1201652"/>
                <a:ext cx="132592" cy="500133"/>
                <a:chOff x="8854922" y="4134571"/>
                <a:chExt cx="132592" cy="500133"/>
              </a:xfrm>
            </p:grpSpPr>
            <p:sp>
              <p:nvSpPr>
                <p:cNvPr id="201" name="Forme libre : forme 200">
                  <a:extLst>
                    <a:ext uri="{FF2B5EF4-FFF2-40B4-BE49-F238E27FC236}">
                      <a16:creationId xmlns:a16="http://schemas.microsoft.com/office/drawing/2014/main" id="{DFAB5A9E-7A5D-472D-BA4C-8F5F0E0F084C}"/>
                    </a:ext>
                  </a:extLst>
                </p:cNvPr>
                <p:cNvSpPr/>
                <p:nvPr/>
              </p:nvSpPr>
              <p:spPr>
                <a:xfrm>
                  <a:off x="8854922" y="4622012"/>
                  <a:ext cx="120996" cy="12692"/>
                </a:xfrm>
                <a:custGeom>
                  <a:avLst/>
                  <a:gdLst>
                    <a:gd name="connsiteX0" fmla="*/ 0 w 178362"/>
                    <a:gd name="connsiteY0" fmla="*/ 0 h 12692"/>
                    <a:gd name="connsiteX1" fmla="*/ 178362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0" y="0"/>
                      </a:moveTo>
                      <a:lnTo>
                        <a:pt x="178362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202" name="Forme libre : forme 201">
                  <a:extLst>
                    <a:ext uri="{FF2B5EF4-FFF2-40B4-BE49-F238E27FC236}">
                      <a16:creationId xmlns:a16="http://schemas.microsoft.com/office/drawing/2014/main" id="{2A82829E-3B07-42C7-AB0B-3A221702EE7A}"/>
                    </a:ext>
                  </a:extLst>
                </p:cNvPr>
                <p:cNvSpPr/>
                <p:nvPr/>
              </p:nvSpPr>
              <p:spPr>
                <a:xfrm>
                  <a:off x="8974820" y="4134571"/>
                  <a:ext cx="12694" cy="487440"/>
                </a:xfrm>
                <a:custGeom>
                  <a:avLst/>
                  <a:gdLst>
                    <a:gd name="connsiteX0" fmla="*/ 0 w 12694"/>
                    <a:gd name="connsiteY0" fmla="*/ 487440 h 487440"/>
                    <a:gd name="connsiteX1" fmla="*/ 0 w 12694"/>
                    <a:gd name="connsiteY1" fmla="*/ 0 h 4874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2694" h="487440">
                      <a:moveTo>
                        <a:pt x="0" y="48744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  <p:sp>
              <p:nvSpPr>
                <p:cNvPr id="203" name="Forme libre : forme 202">
                  <a:extLst>
                    <a:ext uri="{FF2B5EF4-FFF2-40B4-BE49-F238E27FC236}">
                      <a16:creationId xmlns:a16="http://schemas.microsoft.com/office/drawing/2014/main" id="{8CEBBF26-2239-450E-A52E-9F1DB7D46793}"/>
                    </a:ext>
                  </a:extLst>
                </p:cNvPr>
                <p:cNvSpPr/>
                <p:nvPr/>
              </p:nvSpPr>
              <p:spPr>
                <a:xfrm>
                  <a:off x="8854922" y="4134571"/>
                  <a:ext cx="120996" cy="12692"/>
                </a:xfrm>
                <a:custGeom>
                  <a:avLst/>
                  <a:gdLst>
                    <a:gd name="connsiteX0" fmla="*/ 178362 w 178362"/>
                    <a:gd name="connsiteY0" fmla="*/ 0 h 12692"/>
                    <a:gd name="connsiteX1" fmla="*/ 0 w 178362"/>
                    <a:gd name="connsiteY1" fmla="*/ 0 h 1269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</a:cxnLst>
                  <a:rect l="l" t="t" r="r" b="b"/>
                  <a:pathLst>
                    <a:path w="178362" h="12692">
                      <a:moveTo>
                        <a:pt x="178362" y="0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w="3175" cap="sq">
                  <a:solidFill>
                    <a:srgbClr val="000000"/>
                  </a:solidFill>
                  <a:prstDash val="solid"/>
                  <a:round/>
                </a:ln>
              </p:spPr>
              <p:txBody>
                <a:bodyPr rtlCol="0" anchor="ctr"/>
                <a:lstStyle/>
                <a:p>
                  <a:endParaRPr lang="fr-FR"/>
                </a:p>
              </p:txBody>
            </p:sp>
          </p:grpSp>
        </p:grpSp>
      </p:grpSp>
      <p:grpSp>
        <p:nvGrpSpPr>
          <p:cNvPr id="67" name="Groupe 66">
            <a:extLst>
              <a:ext uri="{FF2B5EF4-FFF2-40B4-BE49-F238E27FC236}">
                <a16:creationId xmlns:a16="http://schemas.microsoft.com/office/drawing/2014/main" id="{EE352ED9-0C38-42D5-A0D6-4AA696455BE7}"/>
              </a:ext>
            </a:extLst>
          </p:cNvPr>
          <p:cNvGrpSpPr/>
          <p:nvPr/>
        </p:nvGrpSpPr>
        <p:grpSpPr>
          <a:xfrm>
            <a:off x="8658635" y="442172"/>
            <a:ext cx="2055193" cy="526203"/>
            <a:chOff x="8975739" y="288579"/>
            <a:chExt cx="2055193" cy="526203"/>
          </a:xfrm>
        </p:grpSpPr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id="{ABC62A6B-0EE3-4957-9B26-B4991DC13A37}"/>
                </a:ext>
              </a:extLst>
            </p:cNvPr>
            <p:cNvSpPr txBox="1"/>
            <p:nvPr/>
          </p:nvSpPr>
          <p:spPr>
            <a:xfrm>
              <a:off x="9086297" y="288579"/>
              <a:ext cx="1911101" cy="282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IFN-I score </a:t>
              </a:r>
              <a:r>
                <a:rPr lang="fr-FR" sz="1200" dirty="0" err="1"/>
                <a:t>FilmArray</a:t>
              </a:r>
              <a:r>
                <a:rPr lang="fr-FR" sz="1200" dirty="0"/>
                <a:t>® (NP)</a:t>
              </a:r>
            </a:p>
          </p:txBody>
        </p: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E48490F2-2930-4A7F-B536-B46B95E79F29}"/>
                </a:ext>
              </a:extLst>
            </p:cNvPr>
            <p:cNvSpPr txBox="1"/>
            <p:nvPr/>
          </p:nvSpPr>
          <p:spPr>
            <a:xfrm>
              <a:off x="9086297" y="537783"/>
              <a:ext cx="19446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IP-10 concentration (</a:t>
              </a:r>
              <a:r>
                <a:rPr lang="fr-FR" sz="1200" dirty="0" err="1"/>
                <a:t>pg</a:t>
              </a:r>
              <a:r>
                <a:rPr lang="fr-FR" sz="1200" dirty="0"/>
                <a:t>/</a:t>
              </a:r>
              <a:r>
                <a:rPr lang="fr-FR" sz="1200" dirty="0" err="1"/>
                <a:t>mL</a:t>
              </a:r>
              <a:r>
                <a:rPr lang="fr-FR" sz="1200" dirty="0"/>
                <a:t>)</a:t>
              </a:r>
            </a:p>
          </p:txBody>
        </p:sp>
        <p:sp>
          <p:nvSpPr>
            <p:cNvPr id="206" name="Forme libre : forme 205">
              <a:extLst>
                <a:ext uri="{FF2B5EF4-FFF2-40B4-BE49-F238E27FC236}">
                  <a16:creationId xmlns:a16="http://schemas.microsoft.com/office/drawing/2014/main" id="{E06F01D3-ED49-49BA-9BC2-CD94CB820234}"/>
                </a:ext>
              </a:extLst>
            </p:cNvPr>
            <p:cNvSpPr/>
            <p:nvPr/>
          </p:nvSpPr>
          <p:spPr>
            <a:xfrm>
              <a:off x="8975739" y="373732"/>
              <a:ext cx="110558" cy="111950"/>
            </a:xfrm>
            <a:custGeom>
              <a:avLst/>
              <a:gdLst>
                <a:gd name="connsiteX0" fmla="*/ 0 w 111980"/>
                <a:gd name="connsiteY0" fmla="*/ 111950 h 111950"/>
                <a:gd name="connsiteX1" fmla="*/ 111981 w 111980"/>
                <a:gd name="connsiteY1" fmla="*/ 111950 h 111950"/>
                <a:gd name="connsiteX2" fmla="*/ 111981 w 111980"/>
                <a:gd name="connsiteY2" fmla="*/ 0 h 111950"/>
                <a:gd name="connsiteX3" fmla="*/ 0 w 111980"/>
                <a:gd name="connsiteY3" fmla="*/ 0 h 1119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1980" h="111950">
                  <a:moveTo>
                    <a:pt x="0" y="111950"/>
                  </a:moveTo>
                  <a:lnTo>
                    <a:pt x="111981" y="111950"/>
                  </a:lnTo>
                  <a:lnTo>
                    <a:pt x="11198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 w="9525" cap="rnd">
              <a:solidFill>
                <a:schemeClr val="tx1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  <p:sp>
          <p:nvSpPr>
            <p:cNvPr id="207" name="Forme libre : forme 206">
              <a:extLst>
                <a:ext uri="{FF2B5EF4-FFF2-40B4-BE49-F238E27FC236}">
                  <a16:creationId xmlns:a16="http://schemas.microsoft.com/office/drawing/2014/main" id="{02DDA022-B397-44CC-81BA-8B7A6403B659}"/>
                </a:ext>
              </a:extLst>
            </p:cNvPr>
            <p:cNvSpPr/>
            <p:nvPr/>
          </p:nvSpPr>
          <p:spPr>
            <a:xfrm>
              <a:off x="8975739" y="620307"/>
              <a:ext cx="110558" cy="111950"/>
            </a:xfrm>
            <a:custGeom>
              <a:avLst/>
              <a:gdLst>
                <a:gd name="connsiteX0" fmla="*/ 0 w 111980"/>
                <a:gd name="connsiteY0" fmla="*/ 111950 h 111950"/>
                <a:gd name="connsiteX1" fmla="*/ 111981 w 111980"/>
                <a:gd name="connsiteY1" fmla="*/ 111950 h 111950"/>
                <a:gd name="connsiteX2" fmla="*/ 111981 w 111980"/>
                <a:gd name="connsiteY2" fmla="*/ 0 h 111950"/>
                <a:gd name="connsiteX3" fmla="*/ 0 w 111980"/>
                <a:gd name="connsiteY3" fmla="*/ 0 h 1119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1980" h="111950">
                  <a:moveTo>
                    <a:pt x="0" y="111950"/>
                  </a:moveTo>
                  <a:lnTo>
                    <a:pt x="111981" y="111950"/>
                  </a:lnTo>
                  <a:lnTo>
                    <a:pt x="111981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9525" cap="rnd">
              <a:solidFill>
                <a:schemeClr val="tx1"/>
              </a:solidFill>
              <a:prstDash val="solid"/>
              <a:round/>
            </a:ln>
          </p:spPr>
          <p:txBody>
            <a:bodyPr rtlCol="0" anchor="ctr"/>
            <a:lstStyle/>
            <a:p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40514204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0</TotalTime>
  <Words>136</Words>
  <Application>Microsoft Office PowerPoint</Application>
  <PresentationFormat>Personnalisé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ROSBOIS Cloé</dc:creator>
  <cp:lastModifiedBy>GROSBOIS Cloé</cp:lastModifiedBy>
  <cp:revision>18</cp:revision>
  <dcterms:created xsi:type="dcterms:W3CDTF">2024-07-26T07:49:44Z</dcterms:created>
  <dcterms:modified xsi:type="dcterms:W3CDTF">2024-11-13T15:20:00Z</dcterms:modified>
</cp:coreProperties>
</file>